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57" r:id="rId4"/>
    <p:sldId id="259" r:id="rId5"/>
  </p:sldIdLst>
  <p:sldSz cx="7126288" cy="10210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61C447-18F0-4E49-A6B3-112DAA644779}" v="8" dt="2024-05-16T09:02:21.4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41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4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jørnar Hassel" userId="d39901d0-36a5-4238-ad7a-36d576c03406" providerId="ADAL" clId="{1261C447-18F0-4E49-A6B3-112DAA644779}"/>
    <pc:docChg chg="undo custSel modSld">
      <pc:chgData name="Bjørnar Hassel" userId="d39901d0-36a5-4238-ad7a-36d576c03406" providerId="ADAL" clId="{1261C447-18F0-4E49-A6B3-112DAA644779}" dt="2024-05-16T09:03:39.227" v="471" actId="1035"/>
      <pc:docMkLst>
        <pc:docMk/>
      </pc:docMkLst>
      <pc:sldChg chg="addSp delSp modSp mod">
        <pc:chgData name="Bjørnar Hassel" userId="d39901d0-36a5-4238-ad7a-36d576c03406" providerId="ADAL" clId="{1261C447-18F0-4E49-A6B3-112DAA644779}" dt="2024-05-16T08:59:08.974" v="196" actId="164"/>
        <pc:sldMkLst>
          <pc:docMk/>
          <pc:sldMk cId="431904213" sldId="257"/>
        </pc:sldMkLst>
        <pc:spChg chg="mod">
          <ac:chgData name="Bjørnar Hassel" userId="d39901d0-36a5-4238-ad7a-36d576c03406" providerId="ADAL" clId="{1261C447-18F0-4E49-A6B3-112DAA644779}" dt="2024-05-16T08:56:40.468" v="44" actId="164"/>
          <ac:spMkLst>
            <pc:docMk/>
            <pc:sldMk cId="431904213" sldId="257"/>
            <ac:spMk id="4" creationId="{00000000-0000-0000-0000-000000000000}"/>
          </ac:spMkLst>
        </pc:spChg>
        <pc:spChg chg="add mod">
          <ac:chgData name="Bjørnar Hassel" userId="d39901d0-36a5-4238-ad7a-36d576c03406" providerId="ADAL" clId="{1261C447-18F0-4E49-A6B3-112DAA644779}" dt="2024-05-16T08:59:08.974" v="196" actId="164"/>
          <ac:spMkLst>
            <pc:docMk/>
            <pc:sldMk cId="431904213" sldId="257"/>
            <ac:spMk id="20" creationId="{212D6543-9986-8852-00FF-C9CCA259059B}"/>
          </ac:spMkLst>
        </pc:spChg>
        <pc:spChg chg="mod">
          <ac:chgData name="Bjørnar Hassel" userId="d39901d0-36a5-4238-ad7a-36d576c03406" providerId="ADAL" clId="{1261C447-18F0-4E49-A6B3-112DAA644779}" dt="2024-05-16T08:58:30.044" v="146" actId="1037"/>
          <ac:spMkLst>
            <pc:docMk/>
            <pc:sldMk cId="431904213" sldId="257"/>
            <ac:spMk id="22" creationId="{00000000-0000-0000-0000-000000000000}"/>
          </ac:spMkLst>
        </pc:spChg>
        <pc:spChg chg="mod">
          <ac:chgData name="Bjørnar Hassel" userId="d39901d0-36a5-4238-ad7a-36d576c03406" providerId="ADAL" clId="{1261C447-18F0-4E49-A6B3-112DAA644779}" dt="2024-05-16T08:58:30.044" v="146" actId="1037"/>
          <ac:spMkLst>
            <pc:docMk/>
            <pc:sldMk cId="431904213" sldId="257"/>
            <ac:spMk id="26" creationId="{00000000-0000-0000-0000-000000000000}"/>
          </ac:spMkLst>
        </pc:spChg>
        <pc:spChg chg="mod">
          <ac:chgData name="Bjørnar Hassel" userId="d39901d0-36a5-4238-ad7a-36d576c03406" providerId="ADAL" clId="{1261C447-18F0-4E49-A6B3-112DAA644779}" dt="2024-05-16T08:58:30.044" v="146" actId="1037"/>
          <ac:spMkLst>
            <pc:docMk/>
            <pc:sldMk cId="431904213" sldId="257"/>
            <ac:spMk id="27" creationId="{00000000-0000-0000-0000-000000000000}"/>
          </ac:spMkLst>
        </pc:spChg>
        <pc:grpChg chg="mod">
          <ac:chgData name="Bjørnar Hassel" userId="d39901d0-36a5-4238-ad7a-36d576c03406" providerId="ADAL" clId="{1261C447-18F0-4E49-A6B3-112DAA644779}" dt="2024-05-16T08:56:40.468" v="44" actId="164"/>
          <ac:grpSpMkLst>
            <pc:docMk/>
            <pc:sldMk cId="431904213" sldId="257"/>
            <ac:grpSpMk id="12" creationId="{00000000-0000-0000-0000-000000000000}"/>
          </ac:grpSpMkLst>
        </pc:grpChg>
        <pc:grpChg chg="del">
          <ac:chgData name="Bjørnar Hassel" userId="d39901d0-36a5-4238-ad7a-36d576c03406" providerId="ADAL" clId="{1261C447-18F0-4E49-A6B3-112DAA644779}" dt="2024-05-16T08:55:29.912" v="0" actId="478"/>
          <ac:grpSpMkLst>
            <pc:docMk/>
            <pc:sldMk cId="431904213" sldId="257"/>
            <ac:grpSpMk id="13" creationId="{00000000-0000-0000-0000-000000000000}"/>
          </ac:grpSpMkLst>
        </pc:grpChg>
        <pc:grpChg chg="mod">
          <ac:chgData name="Bjørnar Hassel" userId="d39901d0-36a5-4238-ad7a-36d576c03406" providerId="ADAL" clId="{1261C447-18F0-4E49-A6B3-112DAA644779}" dt="2024-05-16T08:56:40.468" v="44" actId="164"/>
          <ac:grpSpMkLst>
            <pc:docMk/>
            <pc:sldMk cId="431904213" sldId="257"/>
            <ac:grpSpMk id="14" creationId="{00000000-0000-0000-0000-000000000000}"/>
          </ac:grpSpMkLst>
        </pc:grpChg>
        <pc:grpChg chg="mod">
          <ac:chgData name="Bjørnar Hassel" userId="d39901d0-36a5-4238-ad7a-36d576c03406" providerId="ADAL" clId="{1261C447-18F0-4E49-A6B3-112DAA644779}" dt="2024-05-16T08:56:40.468" v="44" actId="164"/>
          <ac:grpSpMkLst>
            <pc:docMk/>
            <pc:sldMk cId="431904213" sldId="257"/>
            <ac:grpSpMk id="15" creationId="{00000000-0000-0000-0000-000000000000}"/>
          </ac:grpSpMkLst>
        </pc:grpChg>
        <pc:grpChg chg="mod">
          <ac:chgData name="Bjørnar Hassel" userId="d39901d0-36a5-4238-ad7a-36d576c03406" providerId="ADAL" clId="{1261C447-18F0-4E49-A6B3-112DAA644779}" dt="2024-05-16T08:56:42.026" v="45" actId="164"/>
          <ac:grpSpMkLst>
            <pc:docMk/>
            <pc:sldMk cId="431904213" sldId="257"/>
            <ac:grpSpMk id="17" creationId="{00000000-0000-0000-0000-000000000000}"/>
          </ac:grpSpMkLst>
        </pc:grpChg>
        <pc:grpChg chg="add mod">
          <ac:chgData name="Bjørnar Hassel" userId="d39901d0-36a5-4238-ad7a-36d576c03406" providerId="ADAL" clId="{1261C447-18F0-4E49-A6B3-112DAA644779}" dt="2024-05-16T08:59:08.974" v="196" actId="164"/>
          <ac:grpSpMkLst>
            <pc:docMk/>
            <pc:sldMk cId="431904213" sldId="257"/>
            <ac:grpSpMk id="19" creationId="{C93CDDB2-4721-6951-C7E0-EB5889BCC1C8}"/>
          </ac:grpSpMkLst>
        </pc:grpChg>
        <pc:grpChg chg="add mod">
          <ac:chgData name="Bjørnar Hassel" userId="d39901d0-36a5-4238-ad7a-36d576c03406" providerId="ADAL" clId="{1261C447-18F0-4E49-A6B3-112DAA644779}" dt="2024-05-16T08:59:08.974" v="196" actId="164"/>
          <ac:grpSpMkLst>
            <pc:docMk/>
            <pc:sldMk cId="431904213" sldId="257"/>
            <ac:grpSpMk id="21" creationId="{FA8BD109-7237-D081-ACF7-C721D48B3943}"/>
          </ac:grpSpMkLst>
        </pc:grpChg>
        <pc:picChg chg="mod">
          <ac:chgData name="Bjørnar Hassel" userId="d39901d0-36a5-4238-ad7a-36d576c03406" providerId="ADAL" clId="{1261C447-18F0-4E49-A6B3-112DAA644779}" dt="2024-05-16T08:58:30.044" v="146" actId="1037"/>
          <ac:picMkLst>
            <pc:docMk/>
            <pc:sldMk cId="431904213" sldId="257"/>
            <ac:picMk id="10" creationId="{00000000-0000-0000-0000-000000000000}"/>
          </ac:picMkLst>
        </pc:picChg>
        <pc:picChg chg="del">
          <ac:chgData name="Bjørnar Hassel" userId="d39901d0-36a5-4238-ad7a-36d576c03406" providerId="ADAL" clId="{1261C447-18F0-4E49-A6B3-112DAA644779}" dt="2024-05-16T08:55:29.912" v="0" actId="478"/>
          <ac:picMkLst>
            <pc:docMk/>
            <pc:sldMk cId="431904213" sldId="257"/>
            <ac:picMk id="11" creationId="{00000000-0000-0000-0000-000000000000}"/>
          </ac:picMkLst>
        </pc:picChg>
        <pc:picChg chg="add mod ord">
          <ac:chgData name="Bjørnar Hassel" userId="d39901d0-36a5-4238-ad7a-36d576c03406" providerId="ADAL" clId="{1261C447-18F0-4E49-A6B3-112DAA644779}" dt="2024-05-16T08:58:30.044" v="146" actId="1037"/>
          <ac:picMkLst>
            <pc:docMk/>
            <pc:sldMk cId="431904213" sldId="257"/>
            <ac:picMk id="18" creationId="{1D24F7EA-030B-BF85-BC1B-F38DD84242B2}"/>
          </ac:picMkLst>
        </pc:picChg>
        <pc:picChg chg="mod ord">
          <ac:chgData name="Bjørnar Hassel" userId="d39901d0-36a5-4238-ad7a-36d576c03406" providerId="ADAL" clId="{1261C447-18F0-4E49-A6B3-112DAA644779}" dt="2024-05-16T08:58:41.545" v="149" actId="1076"/>
          <ac:picMkLst>
            <pc:docMk/>
            <pc:sldMk cId="431904213" sldId="257"/>
            <ac:picMk id="23" creationId="{00000000-0000-0000-0000-000000000000}"/>
          </ac:picMkLst>
        </pc:picChg>
        <pc:cxnChg chg="mod">
          <ac:chgData name="Bjørnar Hassel" userId="d39901d0-36a5-4238-ad7a-36d576c03406" providerId="ADAL" clId="{1261C447-18F0-4E49-A6B3-112DAA644779}" dt="2024-05-16T08:57:17.212" v="80" actId="1038"/>
          <ac:cxnSpMkLst>
            <pc:docMk/>
            <pc:sldMk cId="431904213" sldId="257"/>
            <ac:cxnSpMk id="127" creationId="{00000000-0000-0000-0000-000000000000}"/>
          </ac:cxnSpMkLst>
        </pc:cxnChg>
        <pc:cxnChg chg="mod">
          <ac:chgData name="Bjørnar Hassel" userId="d39901d0-36a5-4238-ad7a-36d576c03406" providerId="ADAL" clId="{1261C447-18F0-4E49-A6B3-112DAA644779}" dt="2024-05-16T08:56:58.432" v="72" actId="1036"/>
          <ac:cxnSpMkLst>
            <pc:docMk/>
            <pc:sldMk cId="431904213" sldId="257"/>
            <ac:cxnSpMk id="128" creationId="{00000000-0000-0000-0000-000000000000}"/>
          </ac:cxnSpMkLst>
        </pc:cxnChg>
      </pc:sldChg>
      <pc:sldChg chg="addSp delSp modSp mod">
        <pc:chgData name="Bjørnar Hassel" userId="d39901d0-36a5-4238-ad7a-36d576c03406" providerId="ADAL" clId="{1261C447-18F0-4E49-A6B3-112DAA644779}" dt="2024-05-16T09:03:39.227" v="471" actId="1035"/>
        <pc:sldMkLst>
          <pc:docMk/>
          <pc:sldMk cId="160377414" sldId="259"/>
        </pc:sldMkLst>
        <pc:spChg chg="mod">
          <ac:chgData name="Bjørnar Hassel" userId="d39901d0-36a5-4238-ad7a-36d576c03406" providerId="ADAL" clId="{1261C447-18F0-4E49-A6B3-112DAA644779}" dt="2024-05-16T09:02:10.350" v="245" actId="1038"/>
          <ac:spMkLst>
            <pc:docMk/>
            <pc:sldMk cId="160377414" sldId="259"/>
            <ac:spMk id="34" creationId="{00000000-0000-0000-0000-000000000000}"/>
          </ac:spMkLst>
        </pc:spChg>
        <pc:grpChg chg="del">
          <ac:chgData name="Bjørnar Hassel" userId="d39901d0-36a5-4238-ad7a-36d576c03406" providerId="ADAL" clId="{1261C447-18F0-4E49-A6B3-112DAA644779}" dt="2024-05-16T09:01:01.301" v="198" actId="478"/>
          <ac:grpSpMkLst>
            <pc:docMk/>
            <pc:sldMk cId="160377414" sldId="259"/>
            <ac:grpSpMk id="37" creationId="{00000000-0000-0000-0000-000000000000}"/>
          </ac:grpSpMkLst>
        </pc:grpChg>
        <pc:grpChg chg="mod">
          <ac:chgData name="Bjørnar Hassel" userId="d39901d0-36a5-4238-ad7a-36d576c03406" providerId="ADAL" clId="{1261C447-18F0-4E49-A6B3-112DAA644779}" dt="2024-05-16T09:01:59.259" v="239" actId="1038"/>
          <ac:grpSpMkLst>
            <pc:docMk/>
            <pc:sldMk cId="160377414" sldId="259"/>
            <ac:grpSpMk id="41" creationId="{00000000-0000-0000-0000-000000000000}"/>
          </ac:grpSpMkLst>
        </pc:grpChg>
        <pc:picChg chg="add mod">
          <ac:chgData name="Bjørnar Hassel" userId="d39901d0-36a5-4238-ad7a-36d576c03406" providerId="ADAL" clId="{1261C447-18F0-4E49-A6B3-112DAA644779}" dt="2024-05-16T09:01:53.966" v="232" actId="1037"/>
          <ac:picMkLst>
            <pc:docMk/>
            <pc:sldMk cId="160377414" sldId="259"/>
            <ac:picMk id="2" creationId="{CF31464E-FB30-57A9-A25A-D3E23C047404}"/>
          </ac:picMkLst>
        </pc:picChg>
        <pc:picChg chg="mod">
          <ac:chgData name="Bjørnar Hassel" userId="d39901d0-36a5-4238-ad7a-36d576c03406" providerId="ADAL" clId="{1261C447-18F0-4E49-A6B3-112DAA644779}" dt="2024-05-16T09:02:05.247" v="243" actId="1038"/>
          <ac:picMkLst>
            <pc:docMk/>
            <pc:sldMk cId="160377414" sldId="259"/>
            <ac:picMk id="30" creationId="{00000000-0000-0000-0000-000000000000}"/>
          </ac:picMkLst>
        </pc:picChg>
        <pc:picChg chg="del">
          <ac:chgData name="Bjørnar Hassel" userId="d39901d0-36a5-4238-ad7a-36d576c03406" providerId="ADAL" clId="{1261C447-18F0-4E49-A6B3-112DAA644779}" dt="2024-05-16T09:01:01.301" v="198" actId="478"/>
          <ac:picMkLst>
            <pc:docMk/>
            <pc:sldMk cId="160377414" sldId="259"/>
            <ac:picMk id="31" creationId="{00000000-0000-0000-0000-000000000000}"/>
          </ac:picMkLst>
        </pc:picChg>
        <pc:cxnChg chg="add mod">
          <ac:chgData name="Bjørnar Hassel" userId="d39901d0-36a5-4238-ad7a-36d576c03406" providerId="ADAL" clId="{1261C447-18F0-4E49-A6B3-112DAA644779}" dt="2024-05-16T09:03:39.227" v="471" actId="1035"/>
          <ac:cxnSpMkLst>
            <pc:docMk/>
            <pc:sldMk cId="160377414" sldId="259"/>
            <ac:cxnSpMk id="3" creationId="{6B0D3939-B047-C5B5-6B60-B5CE7298A571}"/>
          </ac:cxnSpMkLst>
        </pc:cxnChg>
        <pc:cxnChg chg="add mod">
          <ac:chgData name="Bjørnar Hassel" userId="d39901d0-36a5-4238-ad7a-36d576c03406" providerId="ADAL" clId="{1261C447-18F0-4E49-A6B3-112DAA644779}" dt="2024-05-16T09:02:45.577" v="385" actId="1037"/>
          <ac:cxnSpMkLst>
            <pc:docMk/>
            <pc:sldMk cId="160377414" sldId="259"/>
            <ac:cxnSpMk id="4" creationId="{8C26DCFB-81E8-FFFD-4EC8-CF6241116794}"/>
          </ac:cxnSpMkLst>
        </pc:cxnChg>
        <pc:cxnChg chg="mod">
          <ac:chgData name="Bjørnar Hassel" userId="d39901d0-36a5-4238-ad7a-36d576c03406" providerId="ADAL" clId="{1261C447-18F0-4E49-A6B3-112DAA644779}" dt="2024-05-16T09:02:20.237" v="246" actId="1076"/>
          <ac:cxnSpMkLst>
            <pc:docMk/>
            <pc:sldMk cId="160377414" sldId="259"/>
            <ac:cxnSpMk id="70" creationId="{00000000-0000-0000-0000-000000000000}"/>
          </ac:cxnSpMkLst>
        </pc:cxnChg>
        <pc:cxnChg chg="mod">
          <ac:chgData name="Bjørnar Hassel" userId="d39901d0-36a5-4238-ad7a-36d576c03406" providerId="ADAL" clId="{1261C447-18F0-4E49-A6B3-112DAA644779}" dt="2024-05-16T09:02:20.237" v="246" actId="1076"/>
          <ac:cxnSpMkLst>
            <pc:docMk/>
            <pc:sldMk cId="160377414" sldId="259"/>
            <ac:cxnSpMk id="71" creationId="{00000000-0000-0000-0000-00000000000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4472" y="1671074"/>
            <a:ext cx="6057345" cy="3554871"/>
          </a:xfrm>
        </p:spPr>
        <p:txBody>
          <a:bodyPr anchor="b"/>
          <a:lstStyle>
            <a:lvl1pPr algn="ctr">
              <a:defRPr sz="4676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0786" y="5363034"/>
            <a:ext cx="5344716" cy="2465246"/>
          </a:xfrm>
        </p:spPr>
        <p:txBody>
          <a:bodyPr/>
          <a:lstStyle>
            <a:lvl1pPr marL="0" indent="0" algn="ctr">
              <a:buNone/>
              <a:defRPr sz="1870"/>
            </a:lvl1pPr>
            <a:lvl2pPr marL="356296" indent="0" algn="ctr">
              <a:buNone/>
              <a:defRPr sz="1559"/>
            </a:lvl2pPr>
            <a:lvl3pPr marL="712592" indent="0" algn="ctr">
              <a:buNone/>
              <a:defRPr sz="1403"/>
            </a:lvl3pPr>
            <a:lvl4pPr marL="1068888" indent="0" algn="ctr">
              <a:buNone/>
              <a:defRPr sz="1247"/>
            </a:lvl4pPr>
            <a:lvl5pPr marL="1425184" indent="0" algn="ctr">
              <a:buNone/>
              <a:defRPr sz="1247"/>
            </a:lvl5pPr>
            <a:lvl6pPr marL="1781480" indent="0" algn="ctr">
              <a:buNone/>
              <a:defRPr sz="1247"/>
            </a:lvl6pPr>
            <a:lvl7pPr marL="2137776" indent="0" algn="ctr">
              <a:buNone/>
              <a:defRPr sz="1247"/>
            </a:lvl7pPr>
            <a:lvl8pPr marL="2494072" indent="0" algn="ctr">
              <a:buNone/>
              <a:defRPr sz="1247"/>
            </a:lvl8pPr>
            <a:lvl9pPr marL="2850368" indent="0" algn="ctr">
              <a:buNone/>
              <a:defRPr sz="1247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08596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47448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99750" y="543631"/>
            <a:ext cx="1536606" cy="8653181"/>
          </a:xfrm>
        </p:spPr>
        <p:txBody>
          <a:bodyPr vert="eaVert"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9933" y="543631"/>
            <a:ext cx="4520739" cy="8653181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94564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19391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6221" y="2545612"/>
            <a:ext cx="6146423" cy="4247408"/>
          </a:xfrm>
        </p:spPr>
        <p:txBody>
          <a:bodyPr anchor="b"/>
          <a:lstStyle>
            <a:lvl1pPr>
              <a:defRPr sz="4676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6221" y="6833203"/>
            <a:ext cx="6146423" cy="2233612"/>
          </a:xfrm>
        </p:spPr>
        <p:txBody>
          <a:bodyPr/>
          <a:lstStyle>
            <a:lvl1pPr marL="0" indent="0">
              <a:buNone/>
              <a:defRPr sz="1870">
                <a:solidFill>
                  <a:schemeClr val="tx1"/>
                </a:solidFill>
              </a:defRPr>
            </a:lvl1pPr>
            <a:lvl2pPr marL="356296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2pPr>
            <a:lvl3pPr marL="712592" indent="0">
              <a:buNone/>
              <a:defRPr sz="1403">
                <a:solidFill>
                  <a:schemeClr val="tx1">
                    <a:tint val="75000"/>
                  </a:schemeClr>
                </a:solidFill>
              </a:defRPr>
            </a:lvl3pPr>
            <a:lvl4pPr marL="1068888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4pPr>
            <a:lvl5pPr marL="1425184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5pPr>
            <a:lvl6pPr marL="1781480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6pPr>
            <a:lvl7pPr marL="2137776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7pPr>
            <a:lvl8pPr marL="2494072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8pPr>
            <a:lvl9pPr marL="2850368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57706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9933" y="2718153"/>
            <a:ext cx="3028672" cy="6478659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7684" y="2718153"/>
            <a:ext cx="3028672" cy="6478659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91131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861" y="543633"/>
            <a:ext cx="6146423" cy="1973616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0861" y="2503065"/>
            <a:ext cx="3014753" cy="1226713"/>
          </a:xfrm>
        </p:spPr>
        <p:txBody>
          <a:bodyPr anchor="b"/>
          <a:lstStyle>
            <a:lvl1pPr marL="0" indent="0">
              <a:buNone/>
              <a:defRPr sz="1870" b="1"/>
            </a:lvl1pPr>
            <a:lvl2pPr marL="356296" indent="0">
              <a:buNone/>
              <a:defRPr sz="1559" b="1"/>
            </a:lvl2pPr>
            <a:lvl3pPr marL="712592" indent="0">
              <a:buNone/>
              <a:defRPr sz="1403" b="1"/>
            </a:lvl3pPr>
            <a:lvl4pPr marL="1068888" indent="0">
              <a:buNone/>
              <a:defRPr sz="1247" b="1"/>
            </a:lvl4pPr>
            <a:lvl5pPr marL="1425184" indent="0">
              <a:buNone/>
              <a:defRPr sz="1247" b="1"/>
            </a:lvl5pPr>
            <a:lvl6pPr marL="1781480" indent="0">
              <a:buNone/>
              <a:defRPr sz="1247" b="1"/>
            </a:lvl6pPr>
            <a:lvl7pPr marL="2137776" indent="0">
              <a:buNone/>
              <a:defRPr sz="1247" b="1"/>
            </a:lvl7pPr>
            <a:lvl8pPr marL="2494072" indent="0">
              <a:buNone/>
              <a:defRPr sz="1247" b="1"/>
            </a:lvl8pPr>
            <a:lvl9pPr marL="2850368" indent="0">
              <a:buNone/>
              <a:defRPr sz="1247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0861" y="3729778"/>
            <a:ext cx="3014753" cy="5485942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07683" y="2503065"/>
            <a:ext cx="3029601" cy="1226713"/>
          </a:xfrm>
        </p:spPr>
        <p:txBody>
          <a:bodyPr anchor="b"/>
          <a:lstStyle>
            <a:lvl1pPr marL="0" indent="0">
              <a:buNone/>
              <a:defRPr sz="1870" b="1"/>
            </a:lvl1pPr>
            <a:lvl2pPr marL="356296" indent="0">
              <a:buNone/>
              <a:defRPr sz="1559" b="1"/>
            </a:lvl2pPr>
            <a:lvl3pPr marL="712592" indent="0">
              <a:buNone/>
              <a:defRPr sz="1403" b="1"/>
            </a:lvl3pPr>
            <a:lvl4pPr marL="1068888" indent="0">
              <a:buNone/>
              <a:defRPr sz="1247" b="1"/>
            </a:lvl4pPr>
            <a:lvl5pPr marL="1425184" indent="0">
              <a:buNone/>
              <a:defRPr sz="1247" b="1"/>
            </a:lvl5pPr>
            <a:lvl6pPr marL="1781480" indent="0">
              <a:buNone/>
              <a:defRPr sz="1247" b="1"/>
            </a:lvl6pPr>
            <a:lvl7pPr marL="2137776" indent="0">
              <a:buNone/>
              <a:defRPr sz="1247" b="1"/>
            </a:lvl7pPr>
            <a:lvl8pPr marL="2494072" indent="0">
              <a:buNone/>
              <a:defRPr sz="1247" b="1"/>
            </a:lvl8pPr>
            <a:lvl9pPr marL="2850368" indent="0">
              <a:buNone/>
              <a:defRPr sz="1247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07683" y="3729778"/>
            <a:ext cx="3029601" cy="5485942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68846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38700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66080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861" y="680720"/>
            <a:ext cx="2298413" cy="2382520"/>
          </a:xfrm>
        </p:spPr>
        <p:txBody>
          <a:bodyPr anchor="b"/>
          <a:lstStyle>
            <a:lvl1pPr>
              <a:defRPr sz="2494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29601" y="1470168"/>
            <a:ext cx="3607683" cy="7256286"/>
          </a:xfrm>
        </p:spPr>
        <p:txBody>
          <a:bodyPr/>
          <a:lstStyle>
            <a:lvl1pPr>
              <a:defRPr sz="2494"/>
            </a:lvl1pPr>
            <a:lvl2pPr>
              <a:defRPr sz="2182"/>
            </a:lvl2pPr>
            <a:lvl3pPr>
              <a:defRPr sz="1870"/>
            </a:lvl3pPr>
            <a:lvl4pPr>
              <a:defRPr sz="1559"/>
            </a:lvl4pPr>
            <a:lvl5pPr>
              <a:defRPr sz="1559"/>
            </a:lvl5pPr>
            <a:lvl6pPr>
              <a:defRPr sz="1559"/>
            </a:lvl6pPr>
            <a:lvl7pPr>
              <a:defRPr sz="1559"/>
            </a:lvl7pPr>
            <a:lvl8pPr>
              <a:defRPr sz="1559"/>
            </a:lvl8pPr>
            <a:lvl9pPr>
              <a:defRPr sz="1559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0861" y="3063240"/>
            <a:ext cx="2298413" cy="5675031"/>
          </a:xfrm>
        </p:spPr>
        <p:txBody>
          <a:bodyPr/>
          <a:lstStyle>
            <a:lvl1pPr marL="0" indent="0">
              <a:buNone/>
              <a:defRPr sz="1247"/>
            </a:lvl1pPr>
            <a:lvl2pPr marL="356296" indent="0">
              <a:buNone/>
              <a:defRPr sz="1091"/>
            </a:lvl2pPr>
            <a:lvl3pPr marL="712592" indent="0">
              <a:buNone/>
              <a:defRPr sz="935"/>
            </a:lvl3pPr>
            <a:lvl4pPr marL="1068888" indent="0">
              <a:buNone/>
              <a:defRPr sz="779"/>
            </a:lvl4pPr>
            <a:lvl5pPr marL="1425184" indent="0">
              <a:buNone/>
              <a:defRPr sz="779"/>
            </a:lvl5pPr>
            <a:lvl6pPr marL="1781480" indent="0">
              <a:buNone/>
              <a:defRPr sz="779"/>
            </a:lvl6pPr>
            <a:lvl7pPr marL="2137776" indent="0">
              <a:buNone/>
              <a:defRPr sz="779"/>
            </a:lvl7pPr>
            <a:lvl8pPr marL="2494072" indent="0">
              <a:buNone/>
              <a:defRPr sz="779"/>
            </a:lvl8pPr>
            <a:lvl9pPr marL="2850368" indent="0">
              <a:buNone/>
              <a:defRPr sz="779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09325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861" y="680720"/>
            <a:ext cx="2298413" cy="2382520"/>
          </a:xfrm>
        </p:spPr>
        <p:txBody>
          <a:bodyPr anchor="b"/>
          <a:lstStyle>
            <a:lvl1pPr>
              <a:defRPr sz="2494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29601" y="1470168"/>
            <a:ext cx="3607683" cy="7256286"/>
          </a:xfrm>
        </p:spPr>
        <p:txBody>
          <a:bodyPr anchor="t"/>
          <a:lstStyle>
            <a:lvl1pPr marL="0" indent="0">
              <a:buNone/>
              <a:defRPr sz="2494"/>
            </a:lvl1pPr>
            <a:lvl2pPr marL="356296" indent="0">
              <a:buNone/>
              <a:defRPr sz="2182"/>
            </a:lvl2pPr>
            <a:lvl3pPr marL="712592" indent="0">
              <a:buNone/>
              <a:defRPr sz="1870"/>
            </a:lvl3pPr>
            <a:lvl4pPr marL="1068888" indent="0">
              <a:buNone/>
              <a:defRPr sz="1559"/>
            </a:lvl4pPr>
            <a:lvl5pPr marL="1425184" indent="0">
              <a:buNone/>
              <a:defRPr sz="1559"/>
            </a:lvl5pPr>
            <a:lvl6pPr marL="1781480" indent="0">
              <a:buNone/>
              <a:defRPr sz="1559"/>
            </a:lvl6pPr>
            <a:lvl7pPr marL="2137776" indent="0">
              <a:buNone/>
              <a:defRPr sz="1559"/>
            </a:lvl7pPr>
            <a:lvl8pPr marL="2494072" indent="0">
              <a:buNone/>
              <a:defRPr sz="1559"/>
            </a:lvl8pPr>
            <a:lvl9pPr marL="2850368" indent="0">
              <a:buNone/>
              <a:defRPr sz="1559"/>
            </a:lvl9pPr>
          </a:lstStyle>
          <a:p>
            <a:r>
              <a:rPr lang="nb-NO"/>
              <a:t>Klikk ikonet for å legge til et bil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0861" y="3063240"/>
            <a:ext cx="2298413" cy="5675031"/>
          </a:xfrm>
        </p:spPr>
        <p:txBody>
          <a:bodyPr/>
          <a:lstStyle>
            <a:lvl1pPr marL="0" indent="0">
              <a:buNone/>
              <a:defRPr sz="1247"/>
            </a:lvl1pPr>
            <a:lvl2pPr marL="356296" indent="0">
              <a:buNone/>
              <a:defRPr sz="1091"/>
            </a:lvl2pPr>
            <a:lvl3pPr marL="712592" indent="0">
              <a:buNone/>
              <a:defRPr sz="935"/>
            </a:lvl3pPr>
            <a:lvl4pPr marL="1068888" indent="0">
              <a:buNone/>
              <a:defRPr sz="779"/>
            </a:lvl4pPr>
            <a:lvl5pPr marL="1425184" indent="0">
              <a:buNone/>
              <a:defRPr sz="779"/>
            </a:lvl5pPr>
            <a:lvl6pPr marL="1781480" indent="0">
              <a:buNone/>
              <a:defRPr sz="779"/>
            </a:lvl6pPr>
            <a:lvl7pPr marL="2137776" indent="0">
              <a:buNone/>
              <a:defRPr sz="779"/>
            </a:lvl7pPr>
            <a:lvl8pPr marL="2494072" indent="0">
              <a:buNone/>
              <a:defRPr sz="779"/>
            </a:lvl8pPr>
            <a:lvl9pPr marL="2850368" indent="0">
              <a:buNone/>
              <a:defRPr sz="779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68583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9933" y="543633"/>
            <a:ext cx="6146423" cy="19736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933" y="2718153"/>
            <a:ext cx="6146423" cy="64786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9932" y="9463901"/>
            <a:ext cx="1603415" cy="5436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33114-A9A2-477B-9407-B81B15D0534E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60583" y="9463901"/>
            <a:ext cx="2405122" cy="5436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32941" y="9463901"/>
            <a:ext cx="1603415" cy="5436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D8EB7-2D6A-4A29-913B-96BC2FD727C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713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2592" rtl="0" eaLnBrk="1" latinLnBrk="0" hangingPunct="1">
        <a:lnSpc>
          <a:spcPct val="90000"/>
        </a:lnSpc>
        <a:spcBef>
          <a:spcPct val="0"/>
        </a:spcBef>
        <a:buNone/>
        <a:defRPr sz="34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8148" indent="-178148" algn="l" defTabSz="712592" rtl="0" eaLnBrk="1" latinLnBrk="0" hangingPunct="1">
        <a:lnSpc>
          <a:spcPct val="90000"/>
        </a:lnSpc>
        <a:spcBef>
          <a:spcPts val="779"/>
        </a:spcBef>
        <a:buFont typeface="Arial" panose="020B0604020202020204" pitchFamily="34" charset="0"/>
        <a:buChar char="•"/>
        <a:defRPr sz="2182" kern="1200">
          <a:solidFill>
            <a:schemeClr val="tx1"/>
          </a:solidFill>
          <a:latin typeface="+mn-lt"/>
          <a:ea typeface="+mn-ea"/>
          <a:cs typeface="+mn-cs"/>
        </a:defRPr>
      </a:lvl1pPr>
      <a:lvl2pPr marL="534444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870" kern="1200">
          <a:solidFill>
            <a:schemeClr val="tx1"/>
          </a:solidFill>
          <a:latin typeface="+mn-lt"/>
          <a:ea typeface="+mn-ea"/>
          <a:cs typeface="+mn-cs"/>
        </a:defRPr>
      </a:lvl2pPr>
      <a:lvl3pPr marL="890740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247036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4pPr>
      <a:lvl5pPr marL="1603332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5pPr>
      <a:lvl6pPr marL="1959628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6pPr>
      <a:lvl7pPr marL="2315924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7pPr>
      <a:lvl8pPr marL="2672220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8pPr>
      <a:lvl9pPr marL="3028516" indent="-178148" algn="l" defTabSz="712592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1pPr>
      <a:lvl2pPr marL="356296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2pPr>
      <a:lvl3pPr marL="712592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3pPr>
      <a:lvl4pPr marL="1068888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4pPr>
      <a:lvl5pPr marL="1425184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5pPr>
      <a:lvl6pPr marL="1781480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6pPr>
      <a:lvl7pPr marL="2137776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7pPr>
      <a:lvl8pPr marL="2494072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8pPr>
      <a:lvl9pPr marL="2850368" algn="l" defTabSz="712592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/>
          <p:cNvSpPr txBox="1"/>
          <p:nvPr/>
        </p:nvSpPr>
        <p:spPr>
          <a:xfrm>
            <a:off x="742278" y="1043492"/>
            <a:ext cx="6091989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Brain </a:t>
            </a:r>
            <a:r>
              <a:rPr lang="en-US" sz="1200" dirty="0"/>
              <a:t>abscess causes brain damage and long-lasting focal cerebral </a:t>
            </a:r>
            <a:r>
              <a:rPr lang="en-US" sz="1200" dirty="0" err="1"/>
              <a:t>hypoactivity</a:t>
            </a:r>
            <a:r>
              <a:rPr lang="en-US" sz="1200" dirty="0"/>
              <a:t>. </a:t>
            </a:r>
          </a:p>
          <a:p>
            <a:r>
              <a:rPr lang="en-US" sz="1200" dirty="0"/>
              <a:t>A cross-sectional </a:t>
            </a:r>
            <a:r>
              <a:rPr lang="en-US" sz="1200" baseline="30000" dirty="0"/>
              <a:t>18</a:t>
            </a:r>
            <a:r>
              <a:rPr lang="en-US" sz="1200" dirty="0"/>
              <a:t>F-fluoro-deoxyglucose positron emission tomography study.</a:t>
            </a:r>
            <a:endParaRPr lang="nb-NO" sz="1200" dirty="0"/>
          </a:p>
          <a:p>
            <a:r>
              <a:rPr lang="en-US" sz="1200" dirty="0"/>
              <a:t> </a:t>
            </a:r>
          </a:p>
          <a:p>
            <a:endParaRPr lang="en-US" sz="1200" dirty="0"/>
          </a:p>
          <a:p>
            <a:pPr algn="just"/>
            <a:r>
              <a:rPr lang="en-US" sz="1200" b="1" dirty="0"/>
              <a:t>Supplemental </a:t>
            </a:r>
            <a:r>
              <a:rPr lang="en-US" sz="1200" b="1" dirty="0" smtClean="0"/>
              <a:t>Figure </a:t>
            </a:r>
            <a:r>
              <a:rPr lang="en-US" sz="1200" b="1" dirty="0"/>
              <a:t>3</a:t>
            </a:r>
            <a:r>
              <a:rPr lang="en-US" sz="1200" b="1" dirty="0" smtClean="0"/>
              <a:t>.</a:t>
            </a:r>
            <a:endParaRPr lang="en-US" sz="1200" b="1" dirty="0"/>
          </a:p>
          <a:p>
            <a:pPr algn="just"/>
            <a:r>
              <a:rPr lang="nb-NO" sz="1200" dirty="0"/>
              <a:t>Images </a:t>
            </a:r>
            <a:r>
              <a:rPr lang="nb-NO" sz="1200" dirty="0" err="1"/>
              <a:t>of</a:t>
            </a:r>
            <a:r>
              <a:rPr lang="nb-NO" sz="1200" dirty="0"/>
              <a:t> </a:t>
            </a:r>
            <a:r>
              <a:rPr lang="nb-NO" sz="1200" dirty="0" err="1"/>
              <a:t>nine</a:t>
            </a:r>
            <a:r>
              <a:rPr lang="nb-NO" sz="1200" dirty="0"/>
              <a:t> </a:t>
            </a:r>
            <a:r>
              <a:rPr lang="nb-NO" sz="1200" dirty="0" err="1"/>
              <a:t>patients</a:t>
            </a:r>
            <a:r>
              <a:rPr lang="nb-NO" sz="1200" dirty="0"/>
              <a:t> </a:t>
            </a:r>
            <a:r>
              <a:rPr lang="nb-NO" sz="1200" dirty="0" err="1"/>
              <a:t>with</a:t>
            </a:r>
            <a:r>
              <a:rPr lang="nb-NO" sz="1200" dirty="0"/>
              <a:t> </a:t>
            </a:r>
            <a:r>
              <a:rPr lang="nb-NO" sz="1200" dirty="0" err="1"/>
              <a:t>brain</a:t>
            </a:r>
            <a:r>
              <a:rPr lang="nb-NO" sz="1200" dirty="0"/>
              <a:t> abscess and </a:t>
            </a:r>
            <a:r>
              <a:rPr lang="nb-NO" sz="1200" dirty="0" err="1"/>
              <a:t>subsequent</a:t>
            </a:r>
            <a:r>
              <a:rPr lang="nb-NO" sz="1200" dirty="0"/>
              <a:t> </a:t>
            </a:r>
            <a:r>
              <a:rPr lang="nb-NO" sz="1200" dirty="0" err="1"/>
              <a:t>focal</a:t>
            </a:r>
            <a:r>
              <a:rPr lang="nb-NO" sz="1200" dirty="0"/>
              <a:t> </a:t>
            </a:r>
            <a:r>
              <a:rPr lang="nb-NO" sz="1200" dirty="0" err="1"/>
              <a:t>hypometabolism</a:t>
            </a:r>
            <a:r>
              <a:rPr lang="nb-NO" sz="1200" dirty="0"/>
              <a:t> </a:t>
            </a:r>
            <a:r>
              <a:rPr lang="nb-NO" sz="1200" dirty="0" err="1"/>
              <a:t>that</a:t>
            </a:r>
            <a:r>
              <a:rPr lang="nb-NO" sz="1200" dirty="0"/>
              <a:t> </a:t>
            </a:r>
          </a:p>
          <a:p>
            <a:pPr algn="just"/>
            <a:r>
              <a:rPr lang="nb-NO" sz="1200" dirty="0" err="1"/>
              <a:t>coincides</a:t>
            </a:r>
            <a:r>
              <a:rPr lang="nb-NO" sz="1200" dirty="0"/>
              <a:t> </a:t>
            </a:r>
            <a:r>
              <a:rPr lang="nb-NO" sz="1200" dirty="0" err="1"/>
              <a:t>with</a:t>
            </a:r>
            <a:r>
              <a:rPr lang="nb-NO" sz="1200" dirty="0"/>
              <a:t>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peri</a:t>
            </a:r>
            <a:r>
              <a:rPr lang="nb-NO" sz="1200" dirty="0"/>
              <a:t>-abscess </a:t>
            </a:r>
            <a:r>
              <a:rPr lang="nb-NO" sz="1200" dirty="0" err="1"/>
              <a:t>edema</a:t>
            </a:r>
            <a:r>
              <a:rPr lang="nb-NO" sz="1200" dirty="0"/>
              <a:t> </a:t>
            </a:r>
            <a:r>
              <a:rPr lang="nb-NO" sz="1200" dirty="0" err="1"/>
              <a:t>that</a:t>
            </a:r>
            <a:r>
              <a:rPr lang="nb-NO" sz="1200" dirty="0"/>
              <a:t> </a:t>
            </a:r>
            <a:r>
              <a:rPr lang="nb-NO" sz="1200" dirty="0" err="1"/>
              <a:t>occurred</a:t>
            </a:r>
            <a:r>
              <a:rPr lang="nb-NO" sz="1200" dirty="0"/>
              <a:t> in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acute</a:t>
            </a:r>
            <a:r>
              <a:rPr lang="nb-NO" sz="1200" dirty="0"/>
              <a:t> </a:t>
            </a:r>
            <a:r>
              <a:rPr lang="nb-NO" sz="1200" dirty="0" err="1"/>
              <a:t>phase</a:t>
            </a:r>
            <a:r>
              <a:rPr lang="nb-NO" sz="1200" dirty="0"/>
              <a:t> </a:t>
            </a:r>
            <a:r>
              <a:rPr lang="nb-NO" sz="1200" dirty="0" err="1"/>
              <a:t>of</a:t>
            </a:r>
            <a:r>
              <a:rPr lang="nb-NO" sz="1200" dirty="0"/>
              <a:t>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disease</a:t>
            </a:r>
            <a:r>
              <a:rPr lang="nb-NO" sz="1200" dirty="0"/>
              <a:t>.</a:t>
            </a:r>
          </a:p>
          <a:p>
            <a:pPr algn="just"/>
            <a:endParaRPr lang="nb-NO" sz="1200" dirty="0"/>
          </a:p>
          <a:p>
            <a:pPr algn="just"/>
            <a:r>
              <a:rPr lang="nb-NO" sz="1200" dirty="0" err="1"/>
              <a:t>Forty</a:t>
            </a:r>
            <a:r>
              <a:rPr lang="nb-NO" sz="1200" dirty="0"/>
              <a:t> </a:t>
            </a:r>
            <a:r>
              <a:rPr lang="nb-NO" sz="1200" dirty="0" err="1"/>
              <a:t>brain</a:t>
            </a:r>
            <a:r>
              <a:rPr lang="nb-NO" sz="1200" dirty="0"/>
              <a:t> abscess </a:t>
            </a:r>
            <a:r>
              <a:rPr lang="nb-NO" sz="1200" dirty="0" err="1"/>
              <a:t>patients</a:t>
            </a:r>
            <a:r>
              <a:rPr lang="nb-NO" sz="1200" dirty="0"/>
              <a:t> </a:t>
            </a:r>
            <a:r>
              <a:rPr lang="nb-NO" sz="1200" dirty="0" err="1"/>
              <a:t>who</a:t>
            </a:r>
            <a:r>
              <a:rPr lang="nb-NO" sz="1200" dirty="0"/>
              <a:t> </a:t>
            </a:r>
            <a:r>
              <a:rPr lang="nb-NO" sz="1200" dirty="0" err="1"/>
              <a:t>had</a:t>
            </a:r>
            <a:r>
              <a:rPr lang="nb-NO" sz="1200" dirty="0"/>
              <a:t> </a:t>
            </a:r>
            <a:r>
              <a:rPr lang="nb-NO" sz="1200" dirty="0" err="1"/>
              <a:t>been</a:t>
            </a:r>
            <a:r>
              <a:rPr lang="nb-NO" sz="1200" dirty="0"/>
              <a:t> </a:t>
            </a:r>
            <a:r>
              <a:rPr lang="nb-NO" sz="1200" dirty="0" err="1"/>
              <a:t>treated</a:t>
            </a:r>
            <a:r>
              <a:rPr lang="nb-NO" sz="1200" dirty="0"/>
              <a:t> </a:t>
            </a:r>
            <a:r>
              <a:rPr lang="nb-NO" sz="1200" dirty="0" err="1"/>
              <a:t>with</a:t>
            </a:r>
            <a:r>
              <a:rPr lang="nb-NO" sz="1200" dirty="0"/>
              <a:t> </a:t>
            </a:r>
            <a:r>
              <a:rPr lang="nb-NO" sz="1200" dirty="0" err="1"/>
              <a:t>neurosurgical</a:t>
            </a:r>
            <a:r>
              <a:rPr lang="nb-NO" sz="1200" dirty="0"/>
              <a:t> </a:t>
            </a:r>
            <a:r>
              <a:rPr lang="nb-NO" sz="1200" dirty="0" err="1"/>
              <a:t>drainage</a:t>
            </a:r>
            <a:r>
              <a:rPr lang="nb-NO" sz="1200" dirty="0"/>
              <a:t> </a:t>
            </a:r>
            <a:r>
              <a:rPr lang="nb-NO" sz="1200" dirty="0" err="1"/>
              <a:t>of</a:t>
            </a:r>
            <a:r>
              <a:rPr lang="nb-NO" sz="1200" dirty="0"/>
              <a:t> pus </a:t>
            </a:r>
            <a:r>
              <a:rPr lang="nb-NO" sz="1200" dirty="0" err="1"/>
              <a:t>plus</a:t>
            </a:r>
            <a:r>
              <a:rPr lang="nb-NO" sz="1200" dirty="0"/>
              <a:t> </a:t>
            </a:r>
          </a:p>
          <a:p>
            <a:pPr algn="just"/>
            <a:r>
              <a:rPr lang="nb-NO" sz="1200" dirty="0"/>
              <a:t>long-term </a:t>
            </a:r>
            <a:r>
              <a:rPr lang="nb-NO" sz="1200" dirty="0" err="1"/>
              <a:t>antibiotics</a:t>
            </a:r>
            <a:r>
              <a:rPr lang="nb-NO" sz="1200" dirty="0"/>
              <a:t> </a:t>
            </a:r>
            <a:r>
              <a:rPr lang="nb-NO" sz="1200" dirty="0" err="1"/>
              <a:t>underwent</a:t>
            </a:r>
            <a:r>
              <a:rPr lang="nb-NO" sz="1200" dirty="0"/>
              <a:t> FDG-PET/CT </a:t>
            </a:r>
            <a:r>
              <a:rPr lang="nb-NO" sz="1200" dirty="0" err="1"/>
              <a:t>days</a:t>
            </a:r>
            <a:r>
              <a:rPr lang="nb-NO" sz="1200" dirty="0"/>
              <a:t> to </a:t>
            </a:r>
            <a:r>
              <a:rPr lang="nb-NO" sz="1200" dirty="0" err="1"/>
              <a:t>years</a:t>
            </a:r>
            <a:r>
              <a:rPr lang="nb-NO" sz="1200" dirty="0"/>
              <a:t> </a:t>
            </a:r>
            <a:r>
              <a:rPr lang="nb-NO" sz="1200" dirty="0" err="1"/>
              <a:t>after</a:t>
            </a:r>
            <a:r>
              <a:rPr lang="nb-NO" sz="1200" dirty="0"/>
              <a:t> </a:t>
            </a:r>
            <a:r>
              <a:rPr lang="nb-NO" sz="1200" dirty="0" err="1"/>
              <a:t>neurosurgery</a:t>
            </a:r>
            <a:r>
              <a:rPr lang="nb-NO" sz="1200" dirty="0"/>
              <a:t>. </a:t>
            </a:r>
          </a:p>
          <a:p>
            <a:pPr algn="just"/>
            <a:r>
              <a:rPr lang="nb-NO" sz="1200" dirty="0" err="1"/>
              <a:t>Focal</a:t>
            </a:r>
            <a:r>
              <a:rPr lang="nb-NO" sz="1200" dirty="0"/>
              <a:t> </a:t>
            </a:r>
            <a:r>
              <a:rPr lang="nb-NO" sz="1200" dirty="0" err="1"/>
              <a:t>hypometabolism</a:t>
            </a:r>
            <a:r>
              <a:rPr lang="nb-NO" sz="1200" dirty="0"/>
              <a:t> </a:t>
            </a:r>
            <a:r>
              <a:rPr lang="nb-NO" sz="1200" dirty="0" err="1"/>
              <a:t>was</a:t>
            </a:r>
            <a:r>
              <a:rPr lang="nb-NO" sz="1200" dirty="0"/>
              <a:t> evident in 38 </a:t>
            </a:r>
            <a:r>
              <a:rPr lang="nb-NO" sz="1200" dirty="0" err="1"/>
              <a:t>patients</a:t>
            </a:r>
            <a:r>
              <a:rPr lang="nb-NO" sz="1200" dirty="0"/>
              <a:t>. In </a:t>
            </a:r>
            <a:r>
              <a:rPr lang="nb-NO" sz="1200" dirty="0" err="1"/>
              <a:t>nine</a:t>
            </a:r>
            <a:r>
              <a:rPr lang="nb-NO" sz="1200" dirty="0"/>
              <a:t> </a:t>
            </a:r>
            <a:r>
              <a:rPr lang="nb-NO" sz="1200" dirty="0" err="1"/>
              <a:t>patients</a:t>
            </a:r>
            <a:r>
              <a:rPr lang="nb-NO" sz="1200" dirty="0"/>
              <a:t>, </a:t>
            </a:r>
            <a:r>
              <a:rPr lang="nb-NO" sz="1200" dirty="0" err="1"/>
              <a:t>hypometabolism</a:t>
            </a:r>
            <a:r>
              <a:rPr lang="nb-NO" sz="1200" dirty="0"/>
              <a:t> </a:t>
            </a:r>
            <a:r>
              <a:rPr lang="nb-NO" sz="1200" dirty="0" err="1"/>
              <a:t>coincided</a:t>
            </a:r>
            <a:r>
              <a:rPr lang="nb-NO" sz="1200" dirty="0"/>
              <a:t> </a:t>
            </a:r>
          </a:p>
          <a:p>
            <a:pPr algn="just"/>
            <a:r>
              <a:rPr lang="nb-NO" sz="1200" dirty="0" err="1"/>
              <a:t>with</a:t>
            </a:r>
            <a:r>
              <a:rPr lang="nb-NO" sz="1200" dirty="0"/>
              <a:t>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peri</a:t>
            </a:r>
            <a:r>
              <a:rPr lang="nb-NO" sz="1200" dirty="0"/>
              <a:t>-abscess </a:t>
            </a:r>
            <a:r>
              <a:rPr lang="nb-NO" sz="1200" dirty="0" err="1"/>
              <a:t>edema</a:t>
            </a:r>
            <a:r>
              <a:rPr lang="nb-NO" sz="1200" dirty="0"/>
              <a:t> </a:t>
            </a:r>
            <a:r>
              <a:rPr lang="nb-NO" sz="1200" dirty="0" err="1"/>
              <a:t>although</a:t>
            </a:r>
            <a:r>
              <a:rPr lang="nb-NO" sz="1200" dirty="0"/>
              <a:t> in most,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edema</a:t>
            </a:r>
            <a:r>
              <a:rPr lang="nb-NO" sz="1200" dirty="0"/>
              <a:t> </a:t>
            </a:r>
            <a:r>
              <a:rPr lang="nb-NO" sz="1200" dirty="0" err="1"/>
              <a:t>had</a:t>
            </a:r>
            <a:r>
              <a:rPr lang="nb-NO" sz="1200" dirty="0"/>
              <a:t> </a:t>
            </a:r>
            <a:r>
              <a:rPr lang="nb-NO" sz="1200" dirty="0" err="1"/>
              <a:t>resolved</a:t>
            </a:r>
            <a:r>
              <a:rPr lang="nb-NO" sz="1200" dirty="0"/>
              <a:t> at </a:t>
            </a:r>
            <a:r>
              <a:rPr lang="nb-NO" sz="1200" dirty="0" err="1"/>
              <a:t>the</a:t>
            </a:r>
            <a:r>
              <a:rPr lang="nb-NO" sz="1200" dirty="0"/>
              <a:t> time </a:t>
            </a:r>
            <a:r>
              <a:rPr lang="nb-NO" sz="1200" dirty="0" err="1"/>
              <a:t>of</a:t>
            </a:r>
            <a:r>
              <a:rPr lang="nb-NO" sz="1200" dirty="0"/>
              <a:t> </a:t>
            </a:r>
          </a:p>
          <a:p>
            <a:pPr algn="just"/>
            <a:r>
              <a:rPr lang="nb-NO" sz="1200" dirty="0"/>
              <a:t>FDG-PET/CT </a:t>
            </a:r>
            <a:r>
              <a:rPr lang="nb-NO" sz="1200" dirty="0" err="1"/>
              <a:t>investigation</a:t>
            </a:r>
            <a:r>
              <a:rPr lang="nb-NO" sz="1200" dirty="0"/>
              <a:t>. </a:t>
            </a:r>
          </a:p>
          <a:p>
            <a:pPr algn="just"/>
            <a:endParaRPr lang="nb-NO" sz="1200" dirty="0"/>
          </a:p>
          <a:p>
            <a:pPr algn="just"/>
            <a:r>
              <a:rPr lang="nb-NO" sz="1200" dirty="0"/>
              <a:t>In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next</a:t>
            </a:r>
            <a:r>
              <a:rPr lang="nb-NO" sz="1200" dirty="0"/>
              <a:t> </a:t>
            </a:r>
            <a:r>
              <a:rPr lang="nb-NO" sz="1200" dirty="0" err="1"/>
              <a:t>pages</a:t>
            </a:r>
            <a:r>
              <a:rPr lang="nb-NO" sz="1200" dirty="0"/>
              <a:t>,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nine</a:t>
            </a:r>
            <a:r>
              <a:rPr lang="nb-NO" sz="1200" dirty="0"/>
              <a:t> </a:t>
            </a:r>
            <a:r>
              <a:rPr lang="nb-NO" sz="1200" dirty="0" err="1"/>
              <a:t>patients</a:t>
            </a:r>
            <a:r>
              <a:rPr lang="nb-NO" sz="1200" dirty="0"/>
              <a:t> </a:t>
            </a:r>
            <a:r>
              <a:rPr lang="nb-NO" sz="1200" dirty="0" err="1"/>
              <a:t>are</a:t>
            </a:r>
            <a:r>
              <a:rPr lang="nb-NO" sz="1200" dirty="0"/>
              <a:t> </a:t>
            </a:r>
            <a:r>
              <a:rPr lang="nb-NO" sz="1200" dirty="0" err="1"/>
              <a:t>presented</a:t>
            </a:r>
            <a:r>
              <a:rPr lang="nb-NO" sz="1200" dirty="0"/>
              <a:t> </a:t>
            </a:r>
            <a:r>
              <a:rPr lang="nb-NO" sz="1200" dirty="0" err="1"/>
              <a:t>with</a:t>
            </a:r>
            <a:r>
              <a:rPr lang="nb-NO" sz="1200" dirty="0"/>
              <a:t> </a:t>
            </a:r>
            <a:r>
              <a:rPr lang="nb-NO" sz="1200" dirty="0" err="1"/>
              <a:t>those</a:t>
            </a:r>
            <a:r>
              <a:rPr lang="nb-NO" sz="1200" dirty="0"/>
              <a:t> </a:t>
            </a:r>
            <a:r>
              <a:rPr lang="nb-NO" sz="1200" dirty="0" err="1"/>
              <a:t>who</a:t>
            </a:r>
            <a:r>
              <a:rPr lang="nb-NO" sz="1200" dirty="0"/>
              <a:t> </a:t>
            </a:r>
            <a:r>
              <a:rPr lang="nb-NO" sz="1200" dirty="0" err="1"/>
              <a:t>underwent</a:t>
            </a:r>
            <a:r>
              <a:rPr lang="nb-NO" sz="1200" dirty="0"/>
              <a:t> FDG-PET/CT </a:t>
            </a:r>
          </a:p>
          <a:p>
            <a:pPr algn="just"/>
            <a:r>
              <a:rPr lang="nb-NO" sz="1200" dirty="0" err="1"/>
              <a:t>closest</a:t>
            </a:r>
            <a:r>
              <a:rPr lang="nb-NO" sz="1200" dirty="0"/>
              <a:t> to </a:t>
            </a:r>
            <a:r>
              <a:rPr lang="nb-NO" sz="1200" dirty="0" err="1"/>
              <a:t>neurosurgery</a:t>
            </a:r>
            <a:r>
              <a:rPr lang="nb-NO" sz="1200" dirty="0"/>
              <a:t> first. </a:t>
            </a:r>
          </a:p>
        </p:txBody>
      </p:sp>
    </p:spTree>
    <p:extLst>
      <p:ext uri="{BB962C8B-B14F-4D97-AF65-F5344CB8AC3E}">
        <p14:creationId xmlns:p14="http://schemas.microsoft.com/office/powerpoint/2010/main" val="2625568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uppe 57"/>
          <p:cNvGrpSpPr>
            <a:grpSpLocks noChangeAspect="1"/>
          </p:cNvGrpSpPr>
          <p:nvPr/>
        </p:nvGrpSpPr>
        <p:grpSpPr>
          <a:xfrm>
            <a:off x="4641780" y="384870"/>
            <a:ext cx="2297711" cy="2594520"/>
            <a:chOff x="4643604" y="251735"/>
            <a:chExt cx="2511296" cy="2835695"/>
          </a:xfrm>
        </p:grpSpPr>
        <p:pic>
          <p:nvPicPr>
            <p:cNvPr id="2" name="Bild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43604" y="251735"/>
              <a:ext cx="2511296" cy="2835695"/>
            </a:xfrm>
            <a:prstGeom prst="rect">
              <a:avLst/>
            </a:prstGeom>
          </p:spPr>
        </p:pic>
        <p:grpSp>
          <p:nvGrpSpPr>
            <p:cNvPr id="57" name="Gruppe 56"/>
            <p:cNvGrpSpPr/>
            <p:nvPr/>
          </p:nvGrpSpPr>
          <p:grpSpPr>
            <a:xfrm>
              <a:off x="6005016" y="982637"/>
              <a:ext cx="736976" cy="825695"/>
              <a:chOff x="6005016" y="982637"/>
              <a:chExt cx="736976" cy="825695"/>
            </a:xfrm>
          </p:grpSpPr>
          <p:cxnSp>
            <p:nvCxnSpPr>
              <p:cNvPr id="18" name="Rett pilkobling 17"/>
              <p:cNvCxnSpPr/>
              <p:nvPr/>
            </p:nvCxnSpPr>
            <p:spPr>
              <a:xfrm flipH="1">
                <a:off x="6407621" y="982637"/>
                <a:ext cx="143302" cy="129654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Rett pilkobling 45"/>
              <p:cNvCxnSpPr/>
              <p:nvPr/>
            </p:nvCxnSpPr>
            <p:spPr>
              <a:xfrm flipH="1">
                <a:off x="6587317" y="1285165"/>
                <a:ext cx="143302" cy="129654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Rett pilkobling 46"/>
              <p:cNvCxnSpPr/>
              <p:nvPr/>
            </p:nvCxnSpPr>
            <p:spPr>
              <a:xfrm flipH="1" flipV="1">
                <a:off x="6555469" y="1806059"/>
                <a:ext cx="186523" cy="2273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Rett pilkobling 47"/>
              <p:cNvCxnSpPr/>
              <p:nvPr/>
            </p:nvCxnSpPr>
            <p:spPr>
              <a:xfrm>
                <a:off x="6005016" y="1719614"/>
                <a:ext cx="225183" cy="6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Rett pilkobling 48"/>
              <p:cNvCxnSpPr/>
              <p:nvPr/>
            </p:nvCxnSpPr>
            <p:spPr>
              <a:xfrm flipV="1">
                <a:off x="6018656" y="1524002"/>
                <a:ext cx="152400" cy="127377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34F1559-0C83-EC6E-91F1-8246E1F84291}"/>
              </a:ext>
            </a:extLst>
          </p:cNvPr>
          <p:cNvGrpSpPr/>
          <p:nvPr/>
        </p:nvGrpSpPr>
        <p:grpSpPr>
          <a:xfrm>
            <a:off x="248881" y="384870"/>
            <a:ext cx="6780292" cy="2994081"/>
            <a:chOff x="248881" y="384870"/>
            <a:chExt cx="6780292" cy="2994081"/>
          </a:xfrm>
        </p:grpSpPr>
        <p:pic>
          <p:nvPicPr>
            <p:cNvPr id="20" name="Bilde 30">
              <a:extLst>
                <a:ext uri="{FF2B5EF4-FFF2-40B4-BE49-F238E27FC236}">
                  <a16:creationId xmlns:a16="http://schemas.microsoft.com/office/drawing/2014/main" id="{6FDD845F-856B-1A0E-511A-3927AC44C1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91901" y="388417"/>
              <a:ext cx="2230425" cy="2595947"/>
            </a:xfrm>
            <a:prstGeom prst="rect">
              <a:avLst/>
            </a:prstGeom>
          </p:spPr>
        </p:pic>
        <p:grpSp>
          <p:nvGrpSpPr>
            <p:cNvPr id="62" name="Gruppe 61"/>
            <p:cNvGrpSpPr>
              <a:grpSpLocks noChangeAspect="1"/>
            </p:cNvGrpSpPr>
            <p:nvPr/>
          </p:nvGrpSpPr>
          <p:grpSpPr>
            <a:xfrm>
              <a:off x="248881" y="384870"/>
              <a:ext cx="6780292" cy="2994081"/>
              <a:chOff x="77432" y="390714"/>
              <a:chExt cx="7048855" cy="3112674"/>
            </a:xfrm>
          </p:grpSpPr>
          <p:grpSp>
            <p:nvGrpSpPr>
              <p:cNvPr id="60" name="Gruppe 59"/>
              <p:cNvGrpSpPr/>
              <p:nvPr/>
            </p:nvGrpSpPr>
            <p:grpSpPr>
              <a:xfrm>
                <a:off x="77432" y="390714"/>
                <a:ext cx="7048855" cy="3112674"/>
                <a:chOff x="77432" y="390714"/>
                <a:chExt cx="7048855" cy="3112674"/>
              </a:xfrm>
            </p:grpSpPr>
            <p:grpSp>
              <p:nvGrpSpPr>
                <p:cNvPr id="56" name="Gruppe 55"/>
                <p:cNvGrpSpPr/>
                <p:nvPr/>
              </p:nvGrpSpPr>
              <p:grpSpPr>
                <a:xfrm>
                  <a:off x="77432" y="390714"/>
                  <a:ext cx="7048855" cy="3112674"/>
                  <a:chOff x="77432" y="390714"/>
                  <a:chExt cx="7048855" cy="3112674"/>
                </a:xfrm>
              </p:grpSpPr>
              <p:grpSp>
                <p:nvGrpSpPr>
                  <p:cNvPr id="42" name="Gruppe 41"/>
                  <p:cNvGrpSpPr/>
                  <p:nvPr/>
                </p:nvGrpSpPr>
                <p:grpSpPr>
                  <a:xfrm>
                    <a:off x="77432" y="390714"/>
                    <a:ext cx="7048855" cy="3112674"/>
                    <a:chOff x="925157" y="390714"/>
                    <a:chExt cx="7048855" cy="3112674"/>
                  </a:xfrm>
                </p:grpSpPr>
                <p:sp>
                  <p:nvSpPr>
                    <p:cNvPr id="12" name="TekstSylinder 11"/>
                    <p:cNvSpPr txBox="1"/>
                    <p:nvPr/>
                  </p:nvSpPr>
                  <p:spPr>
                    <a:xfrm>
                      <a:off x="925157" y="3087430"/>
                      <a:ext cx="7048855" cy="4159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nb-NO" sz="1000" dirty="0"/>
                        <a:t>a: Abscess (*) in </a:t>
                      </a:r>
                      <a:r>
                        <a:rPr lang="nb-NO" sz="1000" dirty="0" err="1"/>
                        <a:t>left</a:t>
                      </a:r>
                      <a:r>
                        <a:rPr lang="nb-NO" sz="1000" dirty="0"/>
                        <a:t> temporal </a:t>
                      </a:r>
                      <a:r>
                        <a:rPr lang="nb-NO" sz="1000" dirty="0" err="1"/>
                        <a:t>lobe</a:t>
                      </a:r>
                      <a:r>
                        <a:rPr lang="nb-NO" sz="1000" dirty="0"/>
                        <a:t>, b: FDG-PET 30 </a:t>
                      </a:r>
                      <a:r>
                        <a:rPr lang="nb-NO" sz="1000" dirty="0" err="1"/>
                        <a:t>days</a:t>
                      </a:r>
                      <a:r>
                        <a:rPr lang="nb-NO" sz="1000" dirty="0"/>
                        <a:t> later </a:t>
                      </a:r>
                      <a:r>
                        <a:rPr lang="nb-NO" sz="1000" dirty="0" err="1"/>
                        <a:t>showing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extent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of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hypometabolism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coinciding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with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edema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at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surrounded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abscess. c: The </a:t>
                      </a:r>
                      <a:r>
                        <a:rPr lang="nb-NO" sz="1000" dirty="0" err="1"/>
                        <a:t>edema</a:t>
                      </a:r>
                      <a:r>
                        <a:rPr lang="nb-NO" sz="1000" dirty="0"/>
                        <a:t> is still present at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time </a:t>
                      </a:r>
                      <a:r>
                        <a:rPr lang="nb-NO" sz="1000" dirty="0" err="1"/>
                        <a:t>of</a:t>
                      </a:r>
                      <a:r>
                        <a:rPr lang="nb-NO" sz="1000" dirty="0"/>
                        <a:t> FDG-PET/CT (</a:t>
                      </a:r>
                      <a:r>
                        <a:rPr lang="nb-NO" sz="1000" dirty="0" err="1"/>
                        <a:t>arrows</a:t>
                      </a:r>
                      <a:r>
                        <a:rPr lang="nb-NO" sz="1000" dirty="0"/>
                        <a:t>).</a:t>
                      </a:r>
                    </a:p>
                  </p:txBody>
                </p:sp>
                <p:grpSp>
                  <p:nvGrpSpPr>
                    <p:cNvPr id="17" name="Gruppe 16"/>
                    <p:cNvGrpSpPr/>
                    <p:nvPr/>
                  </p:nvGrpSpPr>
                  <p:grpSpPr>
                    <a:xfrm>
                      <a:off x="945523" y="390714"/>
                      <a:ext cx="2523843" cy="2698163"/>
                      <a:chOff x="945523" y="745721"/>
                      <a:chExt cx="2523843" cy="2698163"/>
                    </a:xfrm>
                  </p:grpSpPr>
                  <p:grpSp>
                    <p:nvGrpSpPr>
                      <p:cNvPr id="16" name="Gruppe 15"/>
                      <p:cNvGrpSpPr/>
                      <p:nvPr/>
                    </p:nvGrpSpPr>
                    <p:grpSpPr>
                      <a:xfrm>
                        <a:off x="945523" y="745721"/>
                        <a:ext cx="2182149" cy="2698163"/>
                        <a:chOff x="945523" y="745721"/>
                        <a:chExt cx="2182149" cy="2698163"/>
                      </a:xfrm>
                    </p:grpSpPr>
                    <p:pic>
                      <p:nvPicPr>
                        <p:cNvPr id="11" name="Bilde 10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945528" y="745721"/>
                          <a:ext cx="2182144" cy="2698163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3" name="TekstSylinder 12"/>
                        <p:cNvSpPr txBox="1"/>
                        <p:nvPr/>
                      </p:nvSpPr>
                      <p:spPr>
                        <a:xfrm>
                          <a:off x="945523" y="745722"/>
                          <a:ext cx="295274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nb-NO" dirty="0">
                              <a:solidFill>
                                <a:schemeClr val="bg1"/>
                              </a:solidFill>
                            </a:rPr>
                            <a:t>a</a:t>
                          </a:r>
                        </a:p>
                      </p:txBody>
                    </p:sp>
                  </p:grpSp>
                  <p:sp>
                    <p:nvSpPr>
                      <p:cNvPr id="14" name="TekstSylinder 13"/>
                      <p:cNvSpPr txBox="1"/>
                      <p:nvPr/>
                    </p:nvSpPr>
                    <p:spPr>
                      <a:xfrm>
                        <a:off x="3162872" y="747510"/>
                        <a:ext cx="306494" cy="36933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dirty="0">
                            <a:solidFill>
                              <a:schemeClr val="bg1"/>
                            </a:solidFill>
                          </a:rPr>
                          <a:t>b</a:t>
                        </a:r>
                      </a:p>
                    </p:txBody>
                  </p:sp>
                </p:grpSp>
              </p:grpSp>
              <p:cxnSp>
                <p:nvCxnSpPr>
                  <p:cNvPr id="53" name="Rett pilkobling 52"/>
                  <p:cNvCxnSpPr/>
                  <p:nvPr/>
                </p:nvCxnSpPr>
                <p:spPr>
                  <a:xfrm flipH="1">
                    <a:off x="4055176" y="1002882"/>
                    <a:ext cx="143302" cy="12965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Rett pilkobling 53"/>
                  <p:cNvCxnSpPr/>
                  <p:nvPr/>
                </p:nvCxnSpPr>
                <p:spPr>
                  <a:xfrm flipH="1">
                    <a:off x="4205144" y="1165687"/>
                    <a:ext cx="143302" cy="12965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Rett pilkobling 54"/>
                  <p:cNvCxnSpPr/>
                  <p:nvPr/>
                </p:nvCxnSpPr>
                <p:spPr>
                  <a:xfrm flipH="1" flipV="1">
                    <a:off x="4318908" y="1699731"/>
                    <a:ext cx="186523" cy="2273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9" name="Gruppe 58"/>
                <p:cNvGrpSpPr/>
                <p:nvPr/>
              </p:nvGrpSpPr>
              <p:grpSpPr>
                <a:xfrm>
                  <a:off x="1625856" y="1177433"/>
                  <a:ext cx="363558" cy="782165"/>
                  <a:chOff x="1625856" y="1177433"/>
                  <a:chExt cx="363558" cy="782165"/>
                </a:xfrm>
              </p:grpSpPr>
              <p:cxnSp>
                <p:nvCxnSpPr>
                  <p:cNvPr id="50" name="Rett pilkobling 49"/>
                  <p:cNvCxnSpPr/>
                  <p:nvPr/>
                </p:nvCxnSpPr>
                <p:spPr>
                  <a:xfrm flipH="1">
                    <a:off x="1625856" y="1177433"/>
                    <a:ext cx="143302" cy="12965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Rett pilkobling 50"/>
                  <p:cNvCxnSpPr/>
                  <p:nvPr/>
                </p:nvCxnSpPr>
                <p:spPr>
                  <a:xfrm flipH="1">
                    <a:off x="1846112" y="1442023"/>
                    <a:ext cx="143302" cy="12965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Rett pilkobling 51"/>
                  <p:cNvCxnSpPr/>
                  <p:nvPr/>
                </p:nvCxnSpPr>
                <p:spPr>
                  <a:xfrm flipH="1" flipV="1">
                    <a:off x="1785075" y="1957325"/>
                    <a:ext cx="186522" cy="2273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1" name="TekstSylinder 60"/>
              <p:cNvSpPr txBox="1"/>
              <p:nvPr/>
            </p:nvSpPr>
            <p:spPr>
              <a:xfrm>
                <a:off x="1425103" y="1488997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*</a:t>
                </a:r>
              </a:p>
            </p:txBody>
          </p:sp>
        </p:grpSp>
      </p:grpSp>
      <p:sp>
        <p:nvSpPr>
          <p:cNvPr id="63" name="TekstSylinder 62"/>
          <p:cNvSpPr txBox="1"/>
          <p:nvPr/>
        </p:nvSpPr>
        <p:spPr>
          <a:xfrm>
            <a:off x="4662114" y="38788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c</a:t>
            </a:r>
          </a:p>
        </p:txBody>
      </p:sp>
      <p:cxnSp>
        <p:nvCxnSpPr>
          <p:cNvPr id="64" name="Rett pilkobling 63"/>
          <p:cNvCxnSpPr/>
          <p:nvPr/>
        </p:nvCxnSpPr>
        <p:spPr>
          <a:xfrm flipH="1">
            <a:off x="1865737" y="4413722"/>
            <a:ext cx="137842" cy="12471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Rett pilkobling 64"/>
          <p:cNvCxnSpPr/>
          <p:nvPr/>
        </p:nvCxnSpPr>
        <p:spPr>
          <a:xfrm flipH="1">
            <a:off x="1964643" y="4758732"/>
            <a:ext cx="185252" cy="731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Rett pilkobling 65"/>
          <p:cNvCxnSpPr/>
          <p:nvPr/>
        </p:nvCxnSpPr>
        <p:spPr>
          <a:xfrm flipH="1" flipV="1">
            <a:off x="1922070" y="5131626"/>
            <a:ext cx="131003" cy="12624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kstSylinder 66"/>
          <p:cNvSpPr txBox="1"/>
          <p:nvPr/>
        </p:nvSpPr>
        <p:spPr>
          <a:xfrm>
            <a:off x="1671027" y="4721563"/>
            <a:ext cx="251643" cy="266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/>
              <a:t>*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077553FC-13C6-99D2-8871-094FD671EEA0}"/>
              </a:ext>
            </a:extLst>
          </p:cNvPr>
          <p:cNvGrpSpPr/>
          <p:nvPr/>
        </p:nvGrpSpPr>
        <p:grpSpPr>
          <a:xfrm>
            <a:off x="112930" y="3657304"/>
            <a:ext cx="6900428" cy="2937264"/>
            <a:chOff x="112930" y="3657304"/>
            <a:chExt cx="6900428" cy="2937264"/>
          </a:xfrm>
        </p:grpSpPr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FA5654D4-82E9-0458-B3BB-983D5651F77F}"/>
                </a:ext>
              </a:extLst>
            </p:cNvPr>
            <p:cNvGrpSpPr/>
            <p:nvPr/>
          </p:nvGrpSpPr>
          <p:grpSpPr>
            <a:xfrm>
              <a:off x="112930" y="3657304"/>
              <a:ext cx="6900428" cy="2937264"/>
              <a:chOff x="131612" y="3637622"/>
              <a:chExt cx="6900428" cy="2937264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20AD4AC5-69D4-3B94-BBA6-F8D90790A45D}"/>
                  </a:ext>
                </a:extLst>
              </p:cNvPr>
              <p:cNvGrpSpPr/>
              <p:nvPr/>
            </p:nvGrpSpPr>
            <p:grpSpPr>
              <a:xfrm>
                <a:off x="131612" y="3637622"/>
                <a:ext cx="6900428" cy="2937264"/>
                <a:chOff x="159027" y="3637622"/>
                <a:chExt cx="6900428" cy="2937264"/>
              </a:xfrm>
            </p:grpSpPr>
            <p:grpSp>
              <p:nvGrpSpPr>
                <p:cNvPr id="33" name="Group 32">
                  <a:extLst>
                    <a:ext uri="{FF2B5EF4-FFF2-40B4-BE49-F238E27FC236}">
                      <a16:creationId xmlns:a16="http://schemas.microsoft.com/office/drawing/2014/main" id="{F4591C1C-C306-2A06-55AF-28EF36B43E99}"/>
                    </a:ext>
                  </a:extLst>
                </p:cNvPr>
                <p:cNvGrpSpPr/>
                <p:nvPr/>
              </p:nvGrpSpPr>
              <p:grpSpPr>
                <a:xfrm>
                  <a:off x="2521132" y="3637622"/>
                  <a:ext cx="2184416" cy="2557112"/>
                  <a:chOff x="2525258" y="3638803"/>
                  <a:chExt cx="2184416" cy="2557112"/>
                </a:xfrm>
              </p:grpSpPr>
              <p:pic>
                <p:nvPicPr>
                  <p:cNvPr id="22" name="Bilde 15">
                    <a:extLst>
                      <a:ext uri="{FF2B5EF4-FFF2-40B4-BE49-F238E27FC236}">
                        <a16:creationId xmlns:a16="http://schemas.microsoft.com/office/drawing/2014/main" id="{190546C8-4320-E610-2382-B959114B1A5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2525258" y="3638803"/>
                    <a:ext cx="2184416" cy="2557112"/>
                  </a:xfrm>
                  <a:prstGeom prst="rect">
                    <a:avLst/>
                  </a:prstGeom>
                </p:spPr>
              </p:pic>
              <p:cxnSp>
                <p:nvCxnSpPr>
                  <p:cNvPr id="70" name="Rett pilkobling 69"/>
                  <p:cNvCxnSpPr/>
                  <p:nvPr/>
                </p:nvCxnSpPr>
                <p:spPr>
                  <a:xfrm flipH="1">
                    <a:off x="4257642" y="4392465"/>
                    <a:ext cx="137842" cy="12471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Rett pilkobling 71"/>
                  <p:cNvCxnSpPr>
                    <a:cxnSpLocks/>
                  </p:cNvCxnSpPr>
                  <p:nvPr/>
                </p:nvCxnSpPr>
                <p:spPr>
                  <a:xfrm flipH="1" flipV="1">
                    <a:off x="4451126" y="4952463"/>
                    <a:ext cx="137842" cy="35545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" name="Gruppe 7"/>
                <p:cNvGrpSpPr/>
                <p:nvPr/>
              </p:nvGrpSpPr>
              <p:grpSpPr>
                <a:xfrm>
                  <a:off x="159027" y="3638476"/>
                  <a:ext cx="6900428" cy="2936410"/>
                  <a:chOff x="163153" y="3639657"/>
                  <a:chExt cx="6900428" cy="2936410"/>
                </a:xfrm>
              </p:grpSpPr>
              <p:grpSp>
                <p:nvGrpSpPr>
                  <p:cNvPr id="41" name="Gruppe 40"/>
                  <p:cNvGrpSpPr/>
                  <p:nvPr/>
                </p:nvGrpSpPr>
                <p:grpSpPr>
                  <a:xfrm>
                    <a:off x="163153" y="3641570"/>
                    <a:ext cx="6900428" cy="2934497"/>
                    <a:chOff x="925153" y="3641570"/>
                    <a:chExt cx="6900428" cy="2934497"/>
                  </a:xfrm>
                </p:grpSpPr>
                <p:sp>
                  <p:nvSpPr>
                    <p:cNvPr id="23" name="Rektangel 22"/>
                    <p:cNvSpPr/>
                    <p:nvPr/>
                  </p:nvSpPr>
                  <p:spPr>
                    <a:xfrm>
                      <a:off x="925153" y="6175957"/>
                      <a:ext cx="6900428" cy="400110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000" dirty="0"/>
                        <a:t>a: </a:t>
                      </a:r>
                      <a:r>
                        <a:rPr lang="nb-NO" sz="1000" dirty="0"/>
                        <a:t>Abscess (*) in </a:t>
                      </a:r>
                      <a:r>
                        <a:rPr lang="nb-NO" sz="1000" dirty="0" err="1"/>
                        <a:t>left</a:t>
                      </a:r>
                      <a:r>
                        <a:rPr lang="nb-NO" sz="1000" dirty="0"/>
                        <a:t> temporal </a:t>
                      </a:r>
                      <a:r>
                        <a:rPr lang="nb-NO" sz="1000" dirty="0" err="1"/>
                        <a:t>lobe</a:t>
                      </a:r>
                      <a:r>
                        <a:rPr lang="nb-NO" sz="1000" dirty="0"/>
                        <a:t>, b: FDG-PET/CT 40 </a:t>
                      </a:r>
                      <a:r>
                        <a:rPr lang="nb-NO" sz="1000" dirty="0" err="1"/>
                        <a:t>days</a:t>
                      </a:r>
                      <a:r>
                        <a:rPr lang="nb-NO" sz="1000" dirty="0"/>
                        <a:t> later </a:t>
                      </a:r>
                      <a:r>
                        <a:rPr lang="nb-NO" sz="1000" dirty="0" err="1"/>
                        <a:t>showing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extent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of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hypometabolism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coinciding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with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edema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at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surrounded</a:t>
                      </a:r>
                      <a:r>
                        <a:rPr lang="nb-NO" sz="1000" dirty="0"/>
                        <a:t>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abscess (</a:t>
                      </a:r>
                      <a:r>
                        <a:rPr lang="nb-NO" sz="1000" dirty="0" err="1"/>
                        <a:t>arrows</a:t>
                      </a:r>
                      <a:r>
                        <a:rPr lang="nb-NO" sz="1000" dirty="0"/>
                        <a:t>). c: The </a:t>
                      </a:r>
                      <a:r>
                        <a:rPr lang="nb-NO" sz="1000" dirty="0" err="1"/>
                        <a:t>edema</a:t>
                      </a:r>
                      <a:r>
                        <a:rPr lang="nb-NO" sz="1000" dirty="0"/>
                        <a:t> is still </a:t>
                      </a:r>
                      <a:r>
                        <a:rPr lang="nb-NO" sz="1000" dirty="0" err="1"/>
                        <a:t>largely</a:t>
                      </a:r>
                      <a:r>
                        <a:rPr lang="nb-NO" sz="1000" dirty="0"/>
                        <a:t> present at </a:t>
                      </a:r>
                      <a:r>
                        <a:rPr lang="nb-NO" sz="1000" dirty="0" err="1"/>
                        <a:t>the</a:t>
                      </a:r>
                      <a:r>
                        <a:rPr lang="nb-NO" sz="1000" dirty="0"/>
                        <a:t> time </a:t>
                      </a:r>
                      <a:r>
                        <a:rPr lang="nb-NO" sz="1000" dirty="0" err="1"/>
                        <a:t>of</a:t>
                      </a:r>
                      <a:r>
                        <a:rPr lang="nb-NO" sz="1000" dirty="0"/>
                        <a:t> FDG-PET/CT (</a:t>
                      </a:r>
                      <a:r>
                        <a:rPr lang="nb-NO" sz="1000" dirty="0" err="1"/>
                        <a:t>arrows</a:t>
                      </a:r>
                      <a:r>
                        <a:rPr lang="nb-NO" sz="1000" dirty="0"/>
                        <a:t>).</a:t>
                      </a:r>
                    </a:p>
                  </p:txBody>
                </p:sp>
                <p:grpSp>
                  <p:nvGrpSpPr>
                    <p:cNvPr id="40" name="Gruppe 39"/>
                    <p:cNvGrpSpPr/>
                    <p:nvPr/>
                  </p:nvGrpSpPr>
                  <p:grpSpPr>
                    <a:xfrm>
                      <a:off x="1017300" y="3641570"/>
                      <a:ext cx="2568671" cy="2550369"/>
                      <a:chOff x="1017300" y="4459157"/>
                      <a:chExt cx="2568671" cy="2550369"/>
                    </a:xfrm>
                  </p:grpSpPr>
                  <p:grpSp>
                    <p:nvGrpSpPr>
                      <p:cNvPr id="38" name="Gruppe 37"/>
                      <p:cNvGrpSpPr/>
                      <p:nvPr/>
                    </p:nvGrpSpPr>
                    <p:grpSpPr>
                      <a:xfrm>
                        <a:off x="1017300" y="4459157"/>
                        <a:ext cx="2246656" cy="2550369"/>
                        <a:chOff x="1017300" y="4459157"/>
                        <a:chExt cx="2246656" cy="2550369"/>
                      </a:xfrm>
                    </p:grpSpPr>
                    <p:pic>
                      <p:nvPicPr>
                        <p:cNvPr id="24" name="Bilde 23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56595" y="4459157"/>
                          <a:ext cx="2207361" cy="255036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5" name="TekstSylinder 24"/>
                        <p:cNvSpPr txBox="1"/>
                        <p:nvPr/>
                      </p:nvSpPr>
                      <p:spPr>
                        <a:xfrm>
                          <a:off x="1017300" y="4466208"/>
                          <a:ext cx="295274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nb-NO" dirty="0">
                              <a:solidFill>
                                <a:schemeClr val="bg1"/>
                              </a:solidFill>
                            </a:rPr>
                            <a:t>a</a:t>
                          </a:r>
                        </a:p>
                      </p:txBody>
                    </p:sp>
                  </p:grpSp>
                  <p:sp>
                    <p:nvSpPr>
                      <p:cNvPr id="26" name="TekstSylinder 25"/>
                      <p:cNvSpPr txBox="1"/>
                      <p:nvPr/>
                    </p:nvSpPr>
                    <p:spPr>
                      <a:xfrm>
                        <a:off x="3279477" y="4467996"/>
                        <a:ext cx="306494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dirty="0">
                            <a:solidFill>
                              <a:schemeClr val="bg1"/>
                            </a:solidFill>
                          </a:rPr>
                          <a:t>b</a:t>
                        </a:r>
                      </a:p>
                    </p:txBody>
                  </p:sp>
                </p:grpSp>
              </p:grpSp>
              <p:grpSp>
                <p:nvGrpSpPr>
                  <p:cNvPr id="7" name="Gruppe 6"/>
                  <p:cNvGrpSpPr/>
                  <p:nvPr/>
                </p:nvGrpSpPr>
                <p:grpSpPr>
                  <a:xfrm>
                    <a:off x="4733115" y="3639657"/>
                    <a:ext cx="2229478" cy="2550800"/>
                    <a:chOff x="4733115" y="3639657"/>
                    <a:chExt cx="2229478" cy="2550800"/>
                  </a:xfrm>
                </p:grpSpPr>
                <p:pic>
                  <p:nvPicPr>
                    <p:cNvPr id="3" name="Bilde 2"/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4733115" y="3639657"/>
                      <a:ext cx="2229478" cy="25508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5" name="TekstSylinder 44"/>
                    <p:cNvSpPr txBox="1"/>
                    <p:nvPr/>
                  </p:nvSpPr>
                  <p:spPr>
                    <a:xfrm>
                      <a:off x="4744358" y="3643621"/>
                      <a:ext cx="282450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>
                          <a:solidFill>
                            <a:schemeClr val="bg1"/>
                          </a:solidFill>
                        </a:rPr>
                        <a:t>c</a:t>
                      </a:r>
                    </a:p>
                  </p:txBody>
                </p:sp>
              </p:grpSp>
            </p:grpSp>
          </p:grpSp>
          <p:cxnSp>
            <p:nvCxnSpPr>
              <p:cNvPr id="73" name="Rett pilkobling 72"/>
              <p:cNvCxnSpPr/>
              <p:nvPr/>
            </p:nvCxnSpPr>
            <p:spPr>
              <a:xfrm flipH="1">
                <a:off x="6453593" y="4596023"/>
                <a:ext cx="137842" cy="124714"/>
              </a:xfrm>
              <a:prstGeom prst="straightConnector1">
                <a:avLst/>
              </a:prstGeom>
              <a:ln w="254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Rett pilkobling 73"/>
              <p:cNvCxnSpPr/>
              <p:nvPr/>
            </p:nvCxnSpPr>
            <p:spPr>
              <a:xfrm flipH="1">
                <a:off x="6579914" y="4938026"/>
                <a:ext cx="185252" cy="7318"/>
              </a:xfrm>
              <a:prstGeom prst="straightConnector1">
                <a:avLst/>
              </a:prstGeom>
              <a:ln w="254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B266046-A34A-E74E-DB5A-912D2A4036EE}"/>
                </a:ext>
              </a:extLst>
            </p:cNvPr>
            <p:cNvSpPr txBox="1"/>
            <p:nvPr/>
          </p:nvSpPr>
          <p:spPr>
            <a:xfrm>
              <a:off x="1646627" y="471109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  <a:endParaRPr lang="nb-NO" dirty="0"/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3D35148F-3EBD-A12C-77EC-6ABAB970F1DA}"/>
              </a:ext>
            </a:extLst>
          </p:cNvPr>
          <p:cNvGrpSpPr/>
          <p:nvPr/>
        </p:nvGrpSpPr>
        <p:grpSpPr>
          <a:xfrm>
            <a:off x="304798" y="6917876"/>
            <a:ext cx="6821489" cy="3018898"/>
            <a:chOff x="304798" y="6917876"/>
            <a:chExt cx="6821489" cy="3018898"/>
          </a:xfrm>
        </p:grpSpPr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820FDA10-601C-4BFA-6595-E29FEB84B260}"/>
                </a:ext>
              </a:extLst>
            </p:cNvPr>
            <p:cNvGrpSpPr/>
            <p:nvPr/>
          </p:nvGrpSpPr>
          <p:grpSpPr>
            <a:xfrm>
              <a:off x="304798" y="6917876"/>
              <a:ext cx="6821489" cy="3018898"/>
              <a:chOff x="304798" y="6917876"/>
              <a:chExt cx="6821489" cy="3018898"/>
            </a:xfrm>
          </p:grpSpPr>
          <p:pic>
            <p:nvPicPr>
              <p:cNvPr id="75" name="Bilde 22">
                <a:extLst>
                  <a:ext uri="{FF2B5EF4-FFF2-40B4-BE49-F238E27FC236}">
                    <a16:creationId xmlns:a16="http://schemas.microsoft.com/office/drawing/2014/main" id="{140DBF6E-8414-4953-377B-68F51A0FAD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587564" y="6917876"/>
                <a:ext cx="2075147" cy="2630926"/>
              </a:xfrm>
              <a:prstGeom prst="rect">
                <a:avLst/>
              </a:prstGeom>
            </p:spPr>
          </p:pic>
          <p:grpSp>
            <p:nvGrpSpPr>
              <p:cNvPr id="87" name="Gruppe 86"/>
              <p:cNvGrpSpPr/>
              <p:nvPr/>
            </p:nvGrpSpPr>
            <p:grpSpPr>
              <a:xfrm>
                <a:off x="304798" y="6917876"/>
                <a:ext cx="6821489" cy="3018898"/>
                <a:chOff x="304798" y="7039063"/>
                <a:chExt cx="6821489" cy="3018898"/>
              </a:xfrm>
            </p:grpSpPr>
            <p:grpSp>
              <p:nvGrpSpPr>
                <p:cNvPr id="77" name="Gruppe 76"/>
                <p:cNvGrpSpPr/>
                <p:nvPr/>
              </p:nvGrpSpPr>
              <p:grpSpPr>
                <a:xfrm>
                  <a:off x="304798" y="7039063"/>
                  <a:ext cx="6821489" cy="3018898"/>
                  <a:chOff x="304798" y="7039063"/>
                  <a:chExt cx="6821489" cy="3018898"/>
                </a:xfrm>
              </p:grpSpPr>
              <p:grpSp>
                <p:nvGrpSpPr>
                  <p:cNvPr id="6" name="Gruppe 5"/>
                  <p:cNvGrpSpPr/>
                  <p:nvPr/>
                </p:nvGrpSpPr>
                <p:grpSpPr>
                  <a:xfrm>
                    <a:off x="304798" y="7039063"/>
                    <a:ext cx="6821489" cy="3018898"/>
                    <a:chOff x="304798" y="7039063"/>
                    <a:chExt cx="6821489" cy="3018898"/>
                  </a:xfrm>
                </p:grpSpPr>
                <p:grpSp>
                  <p:nvGrpSpPr>
                    <p:cNvPr id="43" name="Gruppe 42"/>
                    <p:cNvGrpSpPr/>
                    <p:nvPr/>
                  </p:nvGrpSpPr>
                  <p:grpSpPr>
                    <a:xfrm>
                      <a:off x="304798" y="7039063"/>
                      <a:ext cx="6821489" cy="3018898"/>
                      <a:chOff x="977295" y="6643602"/>
                      <a:chExt cx="7874359" cy="3416917"/>
                    </a:xfrm>
                  </p:grpSpPr>
                  <p:grpSp>
                    <p:nvGrpSpPr>
                      <p:cNvPr id="27" name="Gruppe 26"/>
                      <p:cNvGrpSpPr/>
                      <p:nvPr/>
                    </p:nvGrpSpPr>
                    <p:grpSpPr>
                      <a:xfrm>
                        <a:off x="1011231" y="6643602"/>
                        <a:ext cx="2850654" cy="2988197"/>
                        <a:chOff x="1011231" y="5277378"/>
                        <a:chExt cx="2850654" cy="2988197"/>
                      </a:xfrm>
                    </p:grpSpPr>
                    <p:grpSp>
                      <p:nvGrpSpPr>
                        <p:cNvPr id="28" name="Gruppe 27"/>
                        <p:cNvGrpSpPr/>
                        <p:nvPr/>
                      </p:nvGrpSpPr>
                      <p:grpSpPr>
                        <a:xfrm>
                          <a:off x="1011231" y="5277378"/>
                          <a:ext cx="2470322" cy="2988197"/>
                          <a:chOff x="1011231" y="5277378"/>
                          <a:chExt cx="2470322" cy="2988197"/>
                        </a:xfrm>
                      </p:grpSpPr>
                      <p:pic>
                        <p:nvPicPr>
                          <p:cNvPr id="35" name="Bilde 34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011231" y="5277378"/>
                            <a:ext cx="2470322" cy="2988197"/>
                          </a:xfrm>
                          <a:prstGeom prst="rect">
                            <a:avLst/>
                          </a:prstGeom>
                        </p:spPr>
                      </p:pic>
                      <p:sp>
                        <p:nvSpPr>
                          <p:cNvPr id="36" name="TekstSylinder 35"/>
                          <p:cNvSpPr txBox="1"/>
                          <p:nvPr/>
                        </p:nvSpPr>
                        <p:spPr>
                          <a:xfrm>
                            <a:off x="1036308" y="5296332"/>
                            <a:ext cx="295274" cy="3693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nb-NO" dirty="0">
                                <a:solidFill>
                                  <a:schemeClr val="bg1"/>
                                </a:solidFill>
                              </a:rPr>
                              <a:t>a</a:t>
                            </a:r>
                          </a:p>
                        </p:txBody>
                      </p:sp>
                    </p:grpSp>
                    <p:sp>
                      <p:nvSpPr>
                        <p:cNvPr id="31" name="TekstSylinder 30"/>
                        <p:cNvSpPr txBox="1"/>
                        <p:nvPr/>
                      </p:nvSpPr>
                      <p:spPr>
                        <a:xfrm>
                          <a:off x="3555391" y="5298119"/>
                          <a:ext cx="306494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nb-NO" dirty="0">
                              <a:solidFill>
                                <a:schemeClr val="bg1"/>
                              </a:solidFill>
                            </a:rPr>
                            <a:t>b</a:t>
                          </a:r>
                        </a:p>
                      </p:txBody>
                    </p:sp>
                  </p:grpSp>
                  <p:sp>
                    <p:nvSpPr>
                      <p:cNvPr id="37" name="Rektangel 36"/>
                      <p:cNvSpPr/>
                      <p:nvPr/>
                    </p:nvSpPr>
                    <p:spPr>
                      <a:xfrm>
                        <a:off x="977295" y="9607658"/>
                        <a:ext cx="7874359" cy="452861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US" sz="1000" dirty="0"/>
                          <a:t>a: </a:t>
                        </a:r>
                        <a:r>
                          <a:rPr lang="nb-NO" sz="1000" dirty="0"/>
                          <a:t>Abscess in right cerebellar </a:t>
                        </a:r>
                        <a:r>
                          <a:rPr lang="nb-NO" sz="1000" dirty="0" err="1"/>
                          <a:t>hemisphere</a:t>
                        </a:r>
                        <a:r>
                          <a:rPr lang="nb-NO" sz="1000" dirty="0"/>
                          <a:t> (*), b: FDG-PET/CT 47 </a:t>
                        </a:r>
                        <a:r>
                          <a:rPr lang="nb-NO" sz="1000" dirty="0" err="1"/>
                          <a:t>days</a:t>
                        </a:r>
                        <a:r>
                          <a:rPr lang="nb-NO" sz="1000" dirty="0"/>
                          <a:t> later </a:t>
                        </a:r>
                        <a:r>
                          <a:rPr lang="nb-NO" sz="1000" dirty="0" err="1"/>
                          <a:t>showing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extent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of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hypometabolism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coinciding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with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the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edema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that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surrounded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the</a:t>
                        </a:r>
                        <a:r>
                          <a:rPr lang="nb-NO" sz="1000" dirty="0"/>
                          <a:t> abscess (</a:t>
                        </a:r>
                        <a:r>
                          <a:rPr lang="nb-NO" sz="1000" dirty="0" err="1"/>
                          <a:t>arrows</a:t>
                        </a:r>
                        <a:r>
                          <a:rPr lang="nb-NO" sz="1000" dirty="0"/>
                          <a:t>), </a:t>
                        </a:r>
                        <a:r>
                          <a:rPr lang="nb-NO" sz="1000" dirty="0" err="1"/>
                          <a:t>but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which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on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simultaneous</a:t>
                        </a:r>
                        <a:r>
                          <a:rPr lang="nb-NO" sz="1000" dirty="0"/>
                          <a:t> CT (c) is </a:t>
                        </a:r>
                        <a:r>
                          <a:rPr lang="nb-NO" sz="1000" dirty="0" err="1"/>
                          <a:t>largely</a:t>
                        </a:r>
                        <a:r>
                          <a:rPr lang="nb-NO" sz="1000" dirty="0"/>
                          <a:t> </a:t>
                        </a:r>
                        <a:r>
                          <a:rPr lang="nb-NO" sz="1000" dirty="0" err="1"/>
                          <a:t>resolved</a:t>
                        </a:r>
                        <a:r>
                          <a:rPr lang="nb-NO" sz="1000" dirty="0"/>
                          <a:t>.</a:t>
                        </a:r>
                      </a:p>
                    </p:txBody>
                  </p:sp>
                </p:grpSp>
                <p:grpSp>
                  <p:nvGrpSpPr>
                    <p:cNvPr id="5" name="Gruppe 4"/>
                    <p:cNvGrpSpPr/>
                    <p:nvPr/>
                  </p:nvGrpSpPr>
                  <p:grpSpPr>
                    <a:xfrm>
                      <a:off x="4681788" y="7042782"/>
                      <a:ext cx="2346810" cy="2630590"/>
                      <a:chOff x="4681788" y="7042782"/>
                      <a:chExt cx="2346810" cy="2630590"/>
                    </a:xfrm>
                  </p:grpSpPr>
                  <p:pic>
                    <p:nvPicPr>
                      <p:cNvPr id="4" name="Bilde 3"/>
                      <p:cNvPicPr>
                        <a:picLocks noChangeAspect="1"/>
                      </p:cNvPicPr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81788" y="7042782"/>
                        <a:ext cx="2346810" cy="263059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4" name="TekstSylinder 43"/>
                      <p:cNvSpPr txBox="1"/>
                      <p:nvPr/>
                    </p:nvSpPr>
                    <p:spPr>
                      <a:xfrm>
                        <a:off x="4700356" y="7057388"/>
                        <a:ext cx="28245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dirty="0">
                            <a:solidFill>
                              <a:schemeClr val="bg1"/>
                            </a:solidFill>
                          </a:rPr>
                          <a:t>c</a:t>
                        </a:r>
                      </a:p>
                    </p:txBody>
                  </p:sp>
                </p:grpSp>
              </p:grpSp>
              <p:sp>
                <p:nvSpPr>
                  <p:cNvPr id="76" name="TekstSylinder 75"/>
                  <p:cNvSpPr txBox="1"/>
                  <p:nvPr/>
                </p:nvSpPr>
                <p:spPr>
                  <a:xfrm>
                    <a:off x="1100915" y="8696549"/>
                    <a:ext cx="251643" cy="26644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1200" dirty="0"/>
                      <a:t>*</a:t>
                    </a:r>
                  </a:p>
                </p:txBody>
              </p:sp>
            </p:grpSp>
            <p:cxnSp>
              <p:nvCxnSpPr>
                <p:cNvPr id="79" name="Rett pilkobling 78"/>
                <p:cNvCxnSpPr/>
                <p:nvPr/>
              </p:nvCxnSpPr>
              <p:spPr>
                <a:xfrm flipV="1">
                  <a:off x="673181" y="8941426"/>
                  <a:ext cx="183088" cy="65826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Rett pilkobling 83"/>
                <p:cNvCxnSpPr>
                  <a:cxnSpLocks/>
                </p:cNvCxnSpPr>
                <p:nvPr/>
              </p:nvCxnSpPr>
              <p:spPr>
                <a:xfrm>
                  <a:off x="2803693" y="8853068"/>
                  <a:ext cx="215616" cy="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Rett pilkobling 84"/>
                <p:cNvCxnSpPr/>
                <p:nvPr/>
              </p:nvCxnSpPr>
              <p:spPr>
                <a:xfrm flipH="1" flipV="1">
                  <a:off x="3452684" y="9260332"/>
                  <a:ext cx="5195" cy="181841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81" name="Rett pilkobling 84">
              <a:extLst>
                <a:ext uri="{FF2B5EF4-FFF2-40B4-BE49-F238E27FC236}">
                  <a16:creationId xmlns:a16="http://schemas.microsoft.com/office/drawing/2014/main" id="{6B82EA01-FC1C-7111-2964-3B15B5AD01AB}"/>
                </a:ext>
              </a:extLst>
            </p:cNvPr>
            <p:cNvCxnSpPr/>
            <p:nvPr/>
          </p:nvCxnSpPr>
          <p:spPr>
            <a:xfrm flipH="1" flipV="1">
              <a:off x="1175417" y="9128265"/>
              <a:ext cx="5195" cy="181841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319822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e 2">
            <a:extLst>
              <a:ext uri="{FF2B5EF4-FFF2-40B4-BE49-F238E27FC236}">
                <a16:creationId xmlns:a16="http://schemas.microsoft.com/office/drawing/2014/main" id="{EC55C674-890F-EB49-C8DC-EC397D5E83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373" y="311278"/>
            <a:ext cx="2050614" cy="2579200"/>
          </a:xfrm>
          <a:prstGeom prst="rect">
            <a:avLst/>
          </a:prstGeom>
        </p:spPr>
      </p:pic>
      <p:sp>
        <p:nvSpPr>
          <p:cNvPr id="24" name="TekstSylinder 23"/>
          <p:cNvSpPr txBox="1"/>
          <p:nvPr/>
        </p:nvSpPr>
        <p:spPr>
          <a:xfrm>
            <a:off x="1185129" y="92694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a</a:t>
            </a:r>
          </a:p>
        </p:txBody>
      </p:sp>
      <p:grpSp>
        <p:nvGrpSpPr>
          <p:cNvPr id="30" name="Gruppe 29"/>
          <p:cNvGrpSpPr/>
          <p:nvPr/>
        </p:nvGrpSpPr>
        <p:grpSpPr>
          <a:xfrm>
            <a:off x="374815" y="6608499"/>
            <a:ext cx="6237083" cy="3509968"/>
            <a:chOff x="402609" y="660683"/>
            <a:chExt cx="6237083" cy="3509968"/>
          </a:xfrm>
        </p:grpSpPr>
        <p:sp>
          <p:nvSpPr>
            <p:cNvPr id="31" name="TekstSylinder 30"/>
            <p:cNvSpPr txBox="1"/>
            <p:nvPr/>
          </p:nvSpPr>
          <p:spPr>
            <a:xfrm>
              <a:off x="402609" y="3616653"/>
              <a:ext cx="623708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000" dirty="0"/>
                <a:t>a: </a:t>
              </a:r>
              <a:r>
                <a:rPr lang="nb-NO" sz="1000" dirty="0" err="1"/>
                <a:t>Coronal</a:t>
              </a:r>
              <a:r>
                <a:rPr lang="nb-NO" sz="1000" dirty="0"/>
                <a:t> </a:t>
              </a:r>
              <a:r>
                <a:rPr lang="nb-NO" sz="1000" dirty="0" err="1"/>
                <a:t>section</a:t>
              </a:r>
              <a:r>
                <a:rPr lang="nb-NO" sz="1000" dirty="0"/>
                <a:t> </a:t>
              </a:r>
              <a:r>
                <a:rPr lang="nb-NO" sz="1000" dirty="0" err="1"/>
                <a:t>showing</a:t>
              </a:r>
              <a:r>
                <a:rPr lang="nb-NO" sz="1000" dirty="0"/>
                <a:t> abscess in right temporal </a:t>
              </a:r>
              <a:r>
                <a:rPr lang="nb-NO" sz="1000" dirty="0" err="1"/>
                <a:t>lobe</a:t>
              </a:r>
              <a:r>
                <a:rPr lang="nb-NO" sz="1000" dirty="0"/>
                <a:t> (</a:t>
              </a:r>
              <a:r>
                <a:rPr lang="nb-NO" sz="1000" dirty="0" err="1"/>
                <a:t>arrow</a:t>
              </a:r>
              <a:r>
                <a:rPr lang="nb-NO" sz="1000" dirty="0"/>
                <a:t>). b: </a:t>
              </a:r>
              <a:r>
                <a:rPr lang="nb-NO" sz="1000" dirty="0" err="1"/>
                <a:t>Axial</a:t>
              </a:r>
              <a:r>
                <a:rPr lang="nb-NO" sz="1000" dirty="0"/>
                <a:t> </a:t>
              </a:r>
              <a:r>
                <a:rPr lang="nb-NO" sz="1000" dirty="0" err="1"/>
                <a:t>section</a:t>
              </a:r>
              <a:r>
                <a:rPr lang="nb-NO" sz="1000" dirty="0"/>
                <a:t> </a:t>
              </a:r>
              <a:r>
                <a:rPr lang="nb-NO" sz="1000" dirty="0" err="1"/>
                <a:t>showing</a:t>
              </a:r>
              <a:r>
                <a:rPr lang="nb-NO" sz="1000" dirty="0"/>
                <a:t> </a:t>
              </a:r>
              <a:r>
                <a:rPr lang="nb-NO" sz="1000" dirty="0" err="1"/>
                <a:t>extent</a:t>
              </a:r>
              <a:r>
                <a:rPr lang="nb-NO" sz="1000" dirty="0"/>
                <a:t> </a:t>
              </a:r>
              <a:r>
                <a:rPr lang="nb-NO" sz="1000" dirty="0" err="1"/>
                <a:t>of</a:t>
              </a:r>
              <a:r>
                <a:rPr lang="nb-NO" sz="1000" dirty="0"/>
                <a:t> </a:t>
              </a:r>
              <a:r>
                <a:rPr lang="nb-NO" sz="1000" dirty="0" err="1"/>
                <a:t>edema</a:t>
              </a:r>
              <a:r>
                <a:rPr lang="nb-NO" sz="1000" dirty="0"/>
                <a:t> </a:t>
              </a:r>
              <a:r>
                <a:rPr lang="nb-NO" sz="1000" dirty="0" err="1"/>
                <a:t>cranially</a:t>
              </a:r>
              <a:r>
                <a:rPr lang="nb-NO" sz="1000" dirty="0"/>
                <a:t> to </a:t>
              </a:r>
              <a:r>
                <a:rPr lang="nb-NO" sz="1000" dirty="0" err="1"/>
                <a:t>the</a:t>
              </a:r>
              <a:r>
                <a:rPr lang="nb-NO" sz="1000" dirty="0"/>
                <a:t> abscess (</a:t>
              </a:r>
              <a:r>
                <a:rPr lang="nb-NO" sz="1000" dirty="0" err="1"/>
                <a:t>arrows</a:t>
              </a:r>
              <a:r>
                <a:rPr lang="nb-NO" sz="1000" dirty="0"/>
                <a:t>). c: FDG-PET/CT </a:t>
              </a:r>
              <a:r>
                <a:rPr lang="nb-NO" sz="1000" dirty="0" err="1"/>
                <a:t>showing</a:t>
              </a:r>
              <a:r>
                <a:rPr lang="nb-NO" sz="1000" dirty="0"/>
                <a:t> </a:t>
              </a:r>
              <a:r>
                <a:rPr lang="nb-NO" sz="1000" dirty="0" err="1"/>
                <a:t>hypometabolism</a:t>
              </a:r>
              <a:r>
                <a:rPr lang="nb-NO" sz="1000" dirty="0"/>
                <a:t> in </a:t>
              </a:r>
              <a:r>
                <a:rPr lang="nb-NO" sz="1000" dirty="0" err="1"/>
                <a:t>previously</a:t>
              </a:r>
              <a:r>
                <a:rPr lang="nb-NO" sz="1000" dirty="0"/>
                <a:t> </a:t>
              </a:r>
              <a:r>
                <a:rPr lang="nb-NO" sz="1000" dirty="0" err="1"/>
                <a:t>edematous</a:t>
              </a:r>
              <a:r>
                <a:rPr lang="nb-NO" sz="1000" dirty="0"/>
                <a:t> area 21 </a:t>
              </a:r>
              <a:r>
                <a:rPr lang="nb-NO" sz="1000" dirty="0" err="1"/>
                <a:t>months</a:t>
              </a:r>
              <a:r>
                <a:rPr lang="nb-NO" sz="1000" dirty="0"/>
                <a:t> </a:t>
              </a:r>
              <a:r>
                <a:rPr lang="nb-NO" sz="1000" dirty="0" err="1"/>
                <a:t>after</a:t>
              </a:r>
              <a:r>
                <a:rPr lang="nb-NO" sz="1000" dirty="0"/>
                <a:t> </a:t>
              </a:r>
              <a:r>
                <a:rPr lang="nb-NO" sz="1000" dirty="0" err="1"/>
                <a:t>neurosurgery</a:t>
              </a:r>
              <a:r>
                <a:rPr lang="nb-NO" sz="1000" dirty="0"/>
                <a:t>, at </a:t>
              </a:r>
              <a:r>
                <a:rPr lang="nb-NO" sz="1000" dirty="0" err="1"/>
                <a:t>which</a:t>
              </a:r>
              <a:r>
                <a:rPr lang="nb-NO" sz="1000" dirty="0"/>
                <a:t> </a:t>
              </a:r>
              <a:r>
                <a:rPr lang="nb-NO" sz="1000" dirty="0" err="1"/>
                <a:t>point</a:t>
              </a:r>
              <a:r>
                <a:rPr lang="nb-NO" sz="1000" dirty="0"/>
                <a:t> </a:t>
              </a:r>
              <a:r>
                <a:rPr lang="nb-NO" sz="1000" dirty="0" err="1"/>
                <a:t>the</a:t>
              </a:r>
              <a:r>
                <a:rPr lang="nb-NO" sz="1000" dirty="0"/>
                <a:t> </a:t>
              </a:r>
              <a:r>
                <a:rPr lang="nb-NO" sz="1000" dirty="0" err="1"/>
                <a:t>edema</a:t>
              </a:r>
              <a:r>
                <a:rPr lang="nb-NO" sz="1000" dirty="0"/>
                <a:t> </a:t>
              </a:r>
              <a:r>
                <a:rPr lang="nb-NO" sz="1000" dirty="0" err="1"/>
                <a:t>had</a:t>
              </a:r>
              <a:r>
                <a:rPr lang="nb-NO" sz="1000" dirty="0"/>
                <a:t> </a:t>
              </a:r>
              <a:r>
                <a:rPr lang="nb-NO" sz="1000" dirty="0" err="1"/>
                <a:t>resolved</a:t>
              </a:r>
              <a:r>
                <a:rPr lang="nb-NO" sz="1000" dirty="0"/>
                <a:t> (d).  </a:t>
              </a:r>
            </a:p>
          </p:txBody>
        </p:sp>
        <p:grpSp>
          <p:nvGrpSpPr>
            <p:cNvPr id="32" name="Gruppe 31"/>
            <p:cNvGrpSpPr/>
            <p:nvPr/>
          </p:nvGrpSpPr>
          <p:grpSpPr>
            <a:xfrm>
              <a:off x="452307" y="660683"/>
              <a:ext cx="6187385" cy="2983267"/>
              <a:chOff x="452307" y="660683"/>
              <a:chExt cx="6187385" cy="2983267"/>
            </a:xfrm>
          </p:grpSpPr>
          <p:grpSp>
            <p:nvGrpSpPr>
              <p:cNvPr id="33" name="Gruppe 32"/>
              <p:cNvGrpSpPr/>
              <p:nvPr/>
            </p:nvGrpSpPr>
            <p:grpSpPr>
              <a:xfrm>
                <a:off x="4257985" y="662096"/>
                <a:ext cx="2381707" cy="2981853"/>
                <a:chOff x="4257985" y="662096"/>
                <a:chExt cx="2381707" cy="2981853"/>
              </a:xfrm>
            </p:grpSpPr>
            <p:pic>
              <p:nvPicPr>
                <p:cNvPr id="55" name="Bilde 54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257985" y="695962"/>
                  <a:ext cx="2381707" cy="2947987"/>
                </a:xfrm>
                <a:prstGeom prst="rect">
                  <a:avLst/>
                </a:prstGeom>
              </p:spPr>
            </p:pic>
            <p:sp>
              <p:nvSpPr>
                <p:cNvPr id="56" name="TekstSylinder 55"/>
                <p:cNvSpPr txBox="1"/>
                <p:nvPr/>
              </p:nvSpPr>
              <p:spPr>
                <a:xfrm>
                  <a:off x="4264629" y="662096"/>
                  <a:ext cx="3064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d</a:t>
                  </a:r>
                </a:p>
              </p:txBody>
            </p:sp>
          </p:grpSp>
          <p:grpSp>
            <p:nvGrpSpPr>
              <p:cNvPr id="34" name="Gruppe 33"/>
              <p:cNvGrpSpPr/>
              <p:nvPr/>
            </p:nvGrpSpPr>
            <p:grpSpPr>
              <a:xfrm>
                <a:off x="452307" y="1788899"/>
                <a:ext cx="1396831" cy="1855051"/>
                <a:chOff x="452307" y="1788899"/>
                <a:chExt cx="1396831" cy="1855051"/>
              </a:xfrm>
            </p:grpSpPr>
            <p:grpSp>
              <p:nvGrpSpPr>
                <p:cNvPr id="50" name="Gruppe 49"/>
                <p:cNvGrpSpPr/>
                <p:nvPr/>
              </p:nvGrpSpPr>
              <p:grpSpPr>
                <a:xfrm>
                  <a:off x="452307" y="1835621"/>
                  <a:ext cx="1396831" cy="1808329"/>
                  <a:chOff x="452307" y="1835621"/>
                  <a:chExt cx="1396831" cy="1808329"/>
                </a:xfrm>
              </p:grpSpPr>
              <p:pic>
                <p:nvPicPr>
                  <p:cNvPr id="52" name="Bilde 51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452307" y="1835621"/>
                    <a:ext cx="1396831" cy="1808329"/>
                  </a:xfrm>
                  <a:prstGeom prst="rect">
                    <a:avLst/>
                  </a:prstGeom>
                </p:spPr>
              </p:pic>
              <p:cxnSp>
                <p:nvCxnSpPr>
                  <p:cNvPr id="53" name="Rett pilkobling 52"/>
                  <p:cNvCxnSpPr/>
                  <p:nvPr/>
                </p:nvCxnSpPr>
                <p:spPr>
                  <a:xfrm flipV="1">
                    <a:off x="520892" y="3088941"/>
                    <a:ext cx="138747" cy="154674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Rett pilkobling 53"/>
                  <p:cNvCxnSpPr/>
                  <p:nvPr/>
                </p:nvCxnSpPr>
                <p:spPr>
                  <a:xfrm>
                    <a:off x="482217" y="2495260"/>
                    <a:ext cx="152400" cy="152400"/>
                  </a:xfrm>
                  <a:prstGeom prst="straightConnector1">
                    <a:avLst/>
                  </a:prstGeom>
                  <a:ln w="12700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1" name="TekstSylinder 50"/>
                <p:cNvSpPr txBox="1"/>
                <p:nvPr/>
              </p:nvSpPr>
              <p:spPr>
                <a:xfrm>
                  <a:off x="459568" y="1788899"/>
                  <a:ext cx="3064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b</a:t>
                  </a:r>
                </a:p>
              </p:txBody>
            </p:sp>
          </p:grpSp>
          <p:grpSp>
            <p:nvGrpSpPr>
              <p:cNvPr id="35" name="Gruppe 34"/>
              <p:cNvGrpSpPr/>
              <p:nvPr/>
            </p:nvGrpSpPr>
            <p:grpSpPr>
              <a:xfrm>
                <a:off x="452308" y="660683"/>
                <a:ext cx="1396831" cy="1157919"/>
                <a:chOff x="452308" y="660683"/>
                <a:chExt cx="1396831" cy="1157919"/>
              </a:xfrm>
            </p:grpSpPr>
            <p:pic>
              <p:nvPicPr>
                <p:cNvPr id="47" name="Bilde 46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52308" y="695964"/>
                  <a:ext cx="1396831" cy="1122638"/>
                </a:xfrm>
                <a:prstGeom prst="rect">
                  <a:avLst/>
                </a:prstGeom>
              </p:spPr>
            </p:pic>
            <p:sp>
              <p:nvSpPr>
                <p:cNvPr id="48" name="TekstSylinder 47"/>
                <p:cNvSpPr txBox="1"/>
                <p:nvPr/>
              </p:nvSpPr>
              <p:spPr>
                <a:xfrm>
                  <a:off x="457296" y="660683"/>
                  <a:ext cx="233147" cy="2916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a</a:t>
                  </a:r>
                </a:p>
              </p:txBody>
            </p:sp>
            <p:cxnSp>
              <p:nvCxnSpPr>
                <p:cNvPr id="49" name="Rett pilkobling 48"/>
                <p:cNvCxnSpPr/>
                <p:nvPr/>
              </p:nvCxnSpPr>
              <p:spPr>
                <a:xfrm>
                  <a:off x="470843" y="1624087"/>
                  <a:ext cx="191069" cy="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" name="Gruppe 41"/>
              <p:cNvGrpSpPr/>
              <p:nvPr/>
            </p:nvGrpSpPr>
            <p:grpSpPr>
              <a:xfrm>
                <a:off x="1876332" y="662096"/>
                <a:ext cx="2351300" cy="2981854"/>
                <a:chOff x="1876332" y="662096"/>
                <a:chExt cx="2351300" cy="2981854"/>
              </a:xfrm>
            </p:grpSpPr>
            <p:pic>
              <p:nvPicPr>
                <p:cNvPr id="43" name="Bilde 42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876332" y="695963"/>
                  <a:ext cx="2351300" cy="2947987"/>
                </a:xfrm>
                <a:prstGeom prst="rect">
                  <a:avLst/>
                </a:prstGeom>
              </p:spPr>
            </p:pic>
            <p:sp>
              <p:nvSpPr>
                <p:cNvPr id="44" name="TekstSylinder 43"/>
                <p:cNvSpPr txBox="1"/>
                <p:nvPr/>
              </p:nvSpPr>
              <p:spPr>
                <a:xfrm>
                  <a:off x="1883658" y="662096"/>
                  <a:ext cx="28245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c</a:t>
                  </a:r>
                </a:p>
              </p:txBody>
            </p:sp>
            <p:cxnSp>
              <p:nvCxnSpPr>
                <p:cNvPr id="45" name="Rett pilkobling 44"/>
                <p:cNvCxnSpPr/>
                <p:nvPr/>
              </p:nvCxnSpPr>
              <p:spPr>
                <a:xfrm flipV="1">
                  <a:off x="2231416" y="2943365"/>
                  <a:ext cx="138747" cy="15467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Rett pilkobling 45"/>
                <p:cNvCxnSpPr/>
                <p:nvPr/>
              </p:nvCxnSpPr>
              <p:spPr>
                <a:xfrm>
                  <a:off x="1940255" y="2158612"/>
                  <a:ext cx="152400" cy="15240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75" name="Gruppe 74"/>
          <p:cNvGrpSpPr/>
          <p:nvPr/>
        </p:nvGrpSpPr>
        <p:grpSpPr>
          <a:xfrm>
            <a:off x="267370" y="310394"/>
            <a:ext cx="6519942" cy="2989859"/>
            <a:chOff x="267370" y="310394"/>
            <a:chExt cx="6519942" cy="2989859"/>
          </a:xfrm>
        </p:grpSpPr>
        <p:grpSp>
          <p:nvGrpSpPr>
            <p:cNvPr id="69" name="Gruppe 68"/>
            <p:cNvGrpSpPr/>
            <p:nvPr/>
          </p:nvGrpSpPr>
          <p:grpSpPr>
            <a:xfrm>
              <a:off x="267370" y="310394"/>
              <a:ext cx="6519942" cy="2989859"/>
              <a:chOff x="267370" y="310394"/>
              <a:chExt cx="6519942" cy="2989859"/>
            </a:xfrm>
          </p:grpSpPr>
          <p:grpSp>
            <p:nvGrpSpPr>
              <p:cNvPr id="7" name="Gruppe 6"/>
              <p:cNvGrpSpPr/>
              <p:nvPr/>
            </p:nvGrpSpPr>
            <p:grpSpPr>
              <a:xfrm>
                <a:off x="267370" y="310394"/>
                <a:ext cx="6519942" cy="2989859"/>
                <a:chOff x="294666" y="4971115"/>
                <a:chExt cx="6519942" cy="2989859"/>
              </a:xfrm>
            </p:grpSpPr>
            <p:sp>
              <p:nvSpPr>
                <p:cNvPr id="41" name="TekstSylinder 40"/>
                <p:cNvSpPr txBox="1"/>
                <p:nvPr/>
              </p:nvSpPr>
              <p:spPr>
                <a:xfrm>
                  <a:off x="294666" y="7560864"/>
                  <a:ext cx="651994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1000" dirty="0"/>
                    <a:t>a: Abscess in right parietal </a:t>
                  </a:r>
                  <a:r>
                    <a:rPr lang="nb-NO" sz="1000" dirty="0" err="1"/>
                    <a:t>lobe</a:t>
                  </a:r>
                  <a:r>
                    <a:rPr lang="nb-NO" sz="1000" dirty="0"/>
                    <a:t> (*). b: FDG-PET/CT </a:t>
                  </a:r>
                  <a:r>
                    <a:rPr lang="nb-NO" sz="1000" dirty="0" err="1"/>
                    <a:t>after</a:t>
                  </a:r>
                  <a:r>
                    <a:rPr lang="nb-NO" sz="1000" dirty="0"/>
                    <a:t> 10 </a:t>
                  </a:r>
                  <a:r>
                    <a:rPr lang="nb-NO" sz="1000" dirty="0" err="1"/>
                    <a:t>months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show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xtensiv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hypometabolism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conincid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with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original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. c: At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time </a:t>
                  </a:r>
                  <a:r>
                    <a:rPr lang="nb-NO" sz="1000" dirty="0" err="1"/>
                    <a:t>of</a:t>
                  </a:r>
                  <a:r>
                    <a:rPr lang="nb-NO" sz="1000" dirty="0"/>
                    <a:t> FDG-PET/CT,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that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surrounded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abscess is </a:t>
                  </a:r>
                  <a:r>
                    <a:rPr lang="nb-NO" sz="1000" dirty="0" err="1"/>
                    <a:t>resolved</a:t>
                  </a:r>
                  <a:r>
                    <a:rPr lang="nb-NO" sz="1000" dirty="0"/>
                    <a:t>.</a:t>
                  </a:r>
                </a:p>
              </p:txBody>
            </p:sp>
            <p:grpSp>
              <p:nvGrpSpPr>
                <p:cNvPr id="6" name="Gruppe 5"/>
                <p:cNvGrpSpPr/>
                <p:nvPr/>
              </p:nvGrpSpPr>
              <p:grpSpPr>
                <a:xfrm>
                  <a:off x="388369" y="4971115"/>
                  <a:ext cx="6426239" cy="2582210"/>
                  <a:chOff x="388369" y="4971115"/>
                  <a:chExt cx="6426239" cy="2582210"/>
                </a:xfrm>
              </p:grpSpPr>
              <p:grpSp>
                <p:nvGrpSpPr>
                  <p:cNvPr id="40" name="Gruppe 39"/>
                  <p:cNvGrpSpPr>
                    <a:grpSpLocks noChangeAspect="1"/>
                  </p:cNvGrpSpPr>
                  <p:nvPr/>
                </p:nvGrpSpPr>
                <p:grpSpPr>
                  <a:xfrm>
                    <a:off x="388369" y="4971115"/>
                    <a:ext cx="2296930" cy="2582209"/>
                    <a:chOff x="886716" y="5403904"/>
                    <a:chExt cx="2908998" cy="3270295"/>
                  </a:xfrm>
                </p:grpSpPr>
                <p:grpSp>
                  <p:nvGrpSpPr>
                    <p:cNvPr id="38" name="Gruppe 37"/>
                    <p:cNvGrpSpPr/>
                    <p:nvPr/>
                  </p:nvGrpSpPr>
                  <p:grpSpPr>
                    <a:xfrm>
                      <a:off x="886716" y="5403904"/>
                      <a:ext cx="2554061" cy="3270295"/>
                      <a:chOff x="886716" y="5403904"/>
                      <a:chExt cx="2554061" cy="3270295"/>
                    </a:xfrm>
                  </p:grpSpPr>
                  <p:pic>
                    <p:nvPicPr>
                      <p:cNvPr id="8" name="Bilde 7"/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86716" y="5407715"/>
                        <a:ext cx="2554061" cy="3266484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36" name="TekstSylinder 35"/>
                      <p:cNvSpPr txBox="1"/>
                      <p:nvPr/>
                    </p:nvSpPr>
                    <p:spPr>
                      <a:xfrm>
                        <a:off x="901993" y="5403904"/>
                        <a:ext cx="295274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dirty="0">
                            <a:solidFill>
                              <a:schemeClr val="bg1"/>
                            </a:solidFill>
                          </a:rPr>
                          <a:t>a</a:t>
                        </a:r>
                      </a:p>
                    </p:txBody>
                  </p:sp>
                </p:grpSp>
                <p:sp>
                  <p:nvSpPr>
                    <p:cNvPr id="37" name="TekstSylinder 36"/>
                    <p:cNvSpPr txBox="1"/>
                    <p:nvPr/>
                  </p:nvSpPr>
                  <p:spPr>
                    <a:xfrm>
                      <a:off x="3489220" y="5405694"/>
                      <a:ext cx="30649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>
                          <a:solidFill>
                            <a:schemeClr val="bg1"/>
                          </a:solidFill>
                        </a:rPr>
                        <a:t>b</a:t>
                      </a:r>
                    </a:p>
                  </p:txBody>
                </p:sp>
              </p:grpSp>
              <p:grpSp>
                <p:nvGrpSpPr>
                  <p:cNvPr id="5" name="Gruppe 4"/>
                  <p:cNvGrpSpPr/>
                  <p:nvPr/>
                </p:nvGrpSpPr>
                <p:grpSpPr>
                  <a:xfrm>
                    <a:off x="4501348" y="4972528"/>
                    <a:ext cx="2313260" cy="2580797"/>
                    <a:chOff x="4501348" y="4972528"/>
                    <a:chExt cx="2313260" cy="2580797"/>
                  </a:xfrm>
                </p:grpSpPr>
                <p:pic>
                  <p:nvPicPr>
                    <p:cNvPr id="2" name="Bilde 1"/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4501348" y="4974125"/>
                      <a:ext cx="2313260" cy="2579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6" name="TekstSylinder 15"/>
                    <p:cNvSpPr txBox="1"/>
                    <p:nvPr/>
                  </p:nvSpPr>
                  <p:spPr>
                    <a:xfrm>
                      <a:off x="4514840" y="4972528"/>
                      <a:ext cx="282450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>
                          <a:solidFill>
                            <a:schemeClr val="bg1"/>
                          </a:solidFill>
                        </a:rPr>
                        <a:t>c</a:t>
                      </a:r>
                    </a:p>
                  </p:txBody>
                </p:sp>
              </p:grpSp>
            </p:grpSp>
          </p:grpSp>
          <p:cxnSp>
            <p:nvCxnSpPr>
              <p:cNvPr id="60" name="Rett pilkobling 59"/>
              <p:cNvCxnSpPr/>
              <p:nvPr/>
            </p:nvCxnSpPr>
            <p:spPr>
              <a:xfrm rot="-900000" flipH="1" flipV="1">
                <a:off x="470843" y="1550656"/>
                <a:ext cx="96590" cy="136009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Rett pilkobling 60"/>
              <p:cNvCxnSpPr/>
              <p:nvPr/>
            </p:nvCxnSpPr>
            <p:spPr>
              <a:xfrm rot="120000" flipH="1">
                <a:off x="417669" y="2047810"/>
                <a:ext cx="199258" cy="6899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Rett pilkobling 61"/>
              <p:cNvCxnSpPr/>
              <p:nvPr/>
            </p:nvCxnSpPr>
            <p:spPr>
              <a:xfrm flipH="1">
                <a:off x="616927" y="2283385"/>
                <a:ext cx="139852" cy="120949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Rett pilkobling 69"/>
            <p:cNvCxnSpPr/>
            <p:nvPr/>
          </p:nvCxnSpPr>
          <p:spPr>
            <a:xfrm rot="20700000" flipH="1" flipV="1">
              <a:off x="2451497" y="1308248"/>
              <a:ext cx="96590" cy="136009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Rett pilkobling 71"/>
            <p:cNvCxnSpPr/>
            <p:nvPr/>
          </p:nvCxnSpPr>
          <p:spPr>
            <a:xfrm flipH="1">
              <a:off x="2755105" y="2483615"/>
              <a:ext cx="139852" cy="120949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Rett pilkobling 73"/>
            <p:cNvCxnSpPr/>
            <p:nvPr/>
          </p:nvCxnSpPr>
          <p:spPr>
            <a:xfrm rot="120000" flipH="1">
              <a:off x="2412256" y="2050706"/>
              <a:ext cx="199258" cy="6899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" name="TekstSylinder 75"/>
          <p:cNvSpPr txBox="1"/>
          <p:nvPr/>
        </p:nvSpPr>
        <p:spPr>
          <a:xfrm>
            <a:off x="652879" y="182360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  <a:endParaRPr lang="nb-NO" sz="1200" b="1" dirty="0"/>
          </a:p>
        </p:txBody>
      </p:sp>
      <p:sp>
        <p:nvSpPr>
          <p:cNvPr id="121" name="TekstSylinder 120"/>
          <p:cNvSpPr txBox="1"/>
          <p:nvPr/>
        </p:nvSpPr>
        <p:spPr>
          <a:xfrm>
            <a:off x="938601" y="426905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/>
              <a:t>*</a:t>
            </a:r>
          </a:p>
        </p:txBody>
      </p:sp>
      <p:cxnSp>
        <p:nvCxnSpPr>
          <p:cNvPr id="122" name="Rett pilkobling 121"/>
          <p:cNvCxnSpPr/>
          <p:nvPr/>
        </p:nvCxnSpPr>
        <p:spPr>
          <a:xfrm flipH="1" flipV="1">
            <a:off x="841664" y="3800235"/>
            <a:ext cx="137076" cy="134590"/>
          </a:xfrm>
          <a:prstGeom prst="straightConnector1">
            <a:avLst/>
          </a:prstGeom>
          <a:ln w="12700">
            <a:solidFill>
              <a:schemeClr val="bg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Rett pilkobling 122"/>
          <p:cNvCxnSpPr/>
          <p:nvPr/>
        </p:nvCxnSpPr>
        <p:spPr>
          <a:xfrm flipH="1" flipV="1">
            <a:off x="470843" y="4465532"/>
            <a:ext cx="199378" cy="59"/>
          </a:xfrm>
          <a:prstGeom prst="straightConnector1">
            <a:avLst/>
          </a:prstGeom>
          <a:ln w="12700">
            <a:solidFill>
              <a:schemeClr val="bg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A8BD109-7237-D081-ACF7-C721D48B3943}"/>
              </a:ext>
            </a:extLst>
          </p:cNvPr>
          <p:cNvGrpSpPr/>
          <p:nvPr/>
        </p:nvGrpSpPr>
        <p:grpSpPr>
          <a:xfrm>
            <a:off x="332262" y="3557484"/>
            <a:ext cx="6279635" cy="2901023"/>
            <a:chOff x="332262" y="3557484"/>
            <a:chExt cx="6279635" cy="2901023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93CDDB2-4721-6951-C7E0-EB5889BCC1C8}"/>
                </a:ext>
              </a:extLst>
            </p:cNvPr>
            <p:cNvGrpSpPr/>
            <p:nvPr/>
          </p:nvGrpSpPr>
          <p:grpSpPr>
            <a:xfrm>
              <a:off x="332262" y="3557484"/>
              <a:ext cx="6279635" cy="2901023"/>
              <a:chOff x="332262" y="3557484"/>
              <a:chExt cx="6279635" cy="2901023"/>
            </a:xfrm>
          </p:grpSpPr>
          <p:pic>
            <p:nvPicPr>
              <p:cNvPr id="18" name="Bilde 2">
                <a:extLst>
                  <a:ext uri="{FF2B5EF4-FFF2-40B4-BE49-F238E27FC236}">
                    <a16:creationId xmlns:a16="http://schemas.microsoft.com/office/drawing/2014/main" id="{1D24F7EA-030B-BF85-BC1B-F38DD84242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496580" y="3557484"/>
                <a:ext cx="1945487" cy="2348995"/>
              </a:xfrm>
              <a:prstGeom prst="rect">
                <a:avLst/>
              </a:prstGeom>
            </p:spPr>
          </p:pic>
          <p:grpSp>
            <p:nvGrpSpPr>
              <p:cNvPr id="17" name="Gruppe 16"/>
              <p:cNvGrpSpPr/>
              <p:nvPr/>
            </p:nvGrpSpPr>
            <p:grpSpPr>
              <a:xfrm>
                <a:off x="332262" y="3560200"/>
                <a:ext cx="6279635" cy="2898307"/>
                <a:chOff x="332262" y="1274194"/>
                <a:chExt cx="6279635" cy="2898307"/>
              </a:xfrm>
            </p:grpSpPr>
            <p:sp>
              <p:nvSpPr>
                <p:cNvPr id="4" name="TekstSylinder 3"/>
                <p:cNvSpPr txBox="1"/>
                <p:nvPr/>
              </p:nvSpPr>
              <p:spPr>
                <a:xfrm>
                  <a:off x="332262" y="3618503"/>
                  <a:ext cx="6279635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1000" dirty="0"/>
                    <a:t>a: Abscess (*) in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right frontal </a:t>
                  </a:r>
                  <a:r>
                    <a:rPr lang="nb-NO" sz="1000" dirty="0" err="1"/>
                    <a:t>lob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with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xtensiv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surround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(</a:t>
                  </a:r>
                  <a:r>
                    <a:rPr lang="nb-NO" sz="1000" dirty="0" err="1"/>
                    <a:t>arrows</a:t>
                  </a:r>
                  <a:r>
                    <a:rPr lang="nb-NO" sz="1000" dirty="0"/>
                    <a:t>). b: FDG-PET/CT </a:t>
                  </a:r>
                  <a:r>
                    <a:rPr lang="nb-NO" sz="1000" dirty="0" err="1"/>
                    <a:t>after</a:t>
                  </a:r>
                  <a:r>
                    <a:rPr lang="nb-NO" sz="1000" dirty="0"/>
                    <a:t> 14 </a:t>
                  </a:r>
                  <a:r>
                    <a:rPr lang="nb-NO" sz="1000" dirty="0" err="1"/>
                    <a:t>months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show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hypometabolism</a:t>
                  </a:r>
                  <a:r>
                    <a:rPr lang="nb-NO" sz="1000" dirty="0"/>
                    <a:t> (</a:t>
                  </a:r>
                  <a:r>
                    <a:rPr lang="nb-NO" sz="1000" dirty="0" err="1"/>
                    <a:t>arrows</a:t>
                  </a:r>
                  <a:r>
                    <a:rPr lang="nb-NO" sz="1000" dirty="0"/>
                    <a:t>) </a:t>
                  </a:r>
                  <a:r>
                    <a:rPr lang="nb-NO" sz="1000" dirty="0" err="1"/>
                    <a:t>coincid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with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in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acut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phase</a:t>
                  </a:r>
                  <a:r>
                    <a:rPr lang="nb-NO" sz="1000" dirty="0"/>
                    <a:t>. c: At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time </a:t>
                  </a:r>
                  <a:r>
                    <a:rPr lang="nb-NO" sz="1000" dirty="0" err="1"/>
                    <a:t>of</a:t>
                  </a:r>
                  <a:r>
                    <a:rPr lang="nb-NO" sz="1000" dirty="0"/>
                    <a:t> FDG-PET/CT,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has </a:t>
                  </a:r>
                  <a:r>
                    <a:rPr lang="nb-NO" sz="1000" dirty="0" err="1"/>
                    <a:t>resolved</a:t>
                  </a:r>
                  <a:r>
                    <a:rPr lang="nb-NO" sz="1000" dirty="0"/>
                    <a:t>.</a:t>
                  </a:r>
                </a:p>
              </p:txBody>
            </p:sp>
            <p:grpSp>
              <p:nvGrpSpPr>
                <p:cNvPr id="15" name="Gruppe 14"/>
                <p:cNvGrpSpPr/>
                <p:nvPr/>
              </p:nvGrpSpPr>
              <p:grpSpPr>
                <a:xfrm>
                  <a:off x="432059" y="1274194"/>
                  <a:ext cx="6076673" cy="2342463"/>
                  <a:chOff x="432059" y="1274194"/>
                  <a:chExt cx="6076673" cy="2342463"/>
                </a:xfrm>
              </p:grpSpPr>
              <p:grpSp>
                <p:nvGrpSpPr>
                  <p:cNvPr id="14" name="Gruppe 13"/>
                  <p:cNvGrpSpPr/>
                  <p:nvPr/>
                </p:nvGrpSpPr>
                <p:grpSpPr>
                  <a:xfrm>
                    <a:off x="432059" y="1274195"/>
                    <a:ext cx="2023725" cy="2342462"/>
                    <a:chOff x="432059" y="1274195"/>
                    <a:chExt cx="2023725" cy="2342462"/>
                  </a:xfrm>
                </p:grpSpPr>
                <p:pic>
                  <p:nvPicPr>
                    <p:cNvPr id="23" name="Bilde 22"/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tretch>
                      <a:fillRect/>
                    </a:stretch>
                  </p:blipFill>
                  <p:spPr>
                    <a:xfrm>
                      <a:off x="432059" y="1274195"/>
                      <a:ext cx="2023725" cy="234246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2" name="TekstSylinder 21"/>
                    <p:cNvSpPr txBox="1"/>
                    <p:nvPr/>
                  </p:nvSpPr>
                  <p:spPr>
                    <a:xfrm>
                      <a:off x="440425" y="1281659"/>
                      <a:ext cx="233147" cy="29162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>
                          <a:solidFill>
                            <a:schemeClr val="bg1"/>
                          </a:solidFill>
                        </a:rPr>
                        <a:t>a</a:t>
                      </a:r>
                    </a:p>
                  </p:txBody>
                </p:sp>
              </p:grpSp>
              <p:sp>
                <p:nvSpPr>
                  <p:cNvPr id="26" name="TekstSylinder 25"/>
                  <p:cNvSpPr txBox="1"/>
                  <p:nvPr/>
                </p:nvSpPr>
                <p:spPr>
                  <a:xfrm>
                    <a:off x="2508823" y="1283072"/>
                    <a:ext cx="242006" cy="2916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dirty="0">
                        <a:solidFill>
                          <a:schemeClr val="bg1"/>
                        </a:solidFill>
                      </a:rPr>
                      <a:t>b</a:t>
                    </a:r>
                  </a:p>
                </p:txBody>
              </p:sp>
              <p:grpSp>
                <p:nvGrpSpPr>
                  <p:cNvPr id="12" name="Gruppe 11"/>
                  <p:cNvGrpSpPr/>
                  <p:nvPr/>
                </p:nvGrpSpPr>
                <p:grpSpPr>
                  <a:xfrm>
                    <a:off x="4476829" y="1274194"/>
                    <a:ext cx="2031903" cy="2341567"/>
                    <a:chOff x="4476829" y="1274194"/>
                    <a:chExt cx="2031903" cy="2341567"/>
                  </a:xfrm>
                </p:grpSpPr>
                <p:pic>
                  <p:nvPicPr>
                    <p:cNvPr id="10" name="Bilde 9"/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4476829" y="1274194"/>
                      <a:ext cx="2031903" cy="234156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7" name="TekstSylinder 26"/>
                    <p:cNvSpPr txBox="1"/>
                    <p:nvPr/>
                  </p:nvSpPr>
                  <p:spPr>
                    <a:xfrm>
                      <a:off x="4489137" y="1283072"/>
                      <a:ext cx="282450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dirty="0">
                          <a:solidFill>
                            <a:schemeClr val="bg1"/>
                          </a:solidFill>
                        </a:rPr>
                        <a:t>c</a:t>
                      </a:r>
                    </a:p>
                  </p:txBody>
                </p:sp>
              </p:grpSp>
            </p:grpSp>
          </p:grpSp>
          <p:cxnSp>
            <p:nvCxnSpPr>
              <p:cNvPr id="127" name="Rett pilkobling 126"/>
              <p:cNvCxnSpPr/>
              <p:nvPr/>
            </p:nvCxnSpPr>
            <p:spPr>
              <a:xfrm flipH="1" flipV="1">
                <a:off x="2988235" y="3997899"/>
                <a:ext cx="137076" cy="134590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Rett pilkobling 127"/>
              <p:cNvCxnSpPr/>
              <p:nvPr/>
            </p:nvCxnSpPr>
            <p:spPr>
              <a:xfrm flipH="1" flipV="1">
                <a:off x="2658829" y="4403284"/>
                <a:ext cx="199378" cy="59"/>
              </a:xfrm>
              <a:prstGeom prst="straightConnector1">
                <a:avLst/>
              </a:prstGeom>
              <a:ln w="12700">
                <a:solidFill>
                  <a:schemeClr val="bg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12D6543-9986-8852-00FF-C9CCA259059B}"/>
                </a:ext>
              </a:extLst>
            </p:cNvPr>
            <p:cNvSpPr txBox="1"/>
            <p:nvPr/>
          </p:nvSpPr>
          <p:spPr>
            <a:xfrm>
              <a:off x="998833" y="4220406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  <a:endParaRPr lang="nb-NO" dirty="0"/>
            </a:p>
          </p:txBody>
        </p:sp>
      </p:grpSp>
    </p:spTree>
    <p:extLst>
      <p:ext uri="{BB962C8B-B14F-4D97-AF65-F5344CB8AC3E}">
        <p14:creationId xmlns:p14="http://schemas.microsoft.com/office/powerpoint/2010/main" val="431904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e 40"/>
          <p:cNvGrpSpPr/>
          <p:nvPr/>
        </p:nvGrpSpPr>
        <p:grpSpPr>
          <a:xfrm>
            <a:off x="103345" y="272475"/>
            <a:ext cx="6792184" cy="2589697"/>
            <a:chOff x="122938" y="503832"/>
            <a:chExt cx="6792184" cy="2589697"/>
          </a:xfrm>
        </p:grpSpPr>
        <p:sp>
          <p:nvSpPr>
            <p:cNvPr id="32" name="TekstSylinder 31"/>
            <p:cNvSpPr txBox="1"/>
            <p:nvPr/>
          </p:nvSpPr>
          <p:spPr>
            <a:xfrm>
              <a:off x="122938" y="2539531"/>
              <a:ext cx="679218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000" dirty="0"/>
                <a:t>a: T1-weighted MRI </a:t>
              </a:r>
              <a:r>
                <a:rPr lang="nb-NO" sz="1000" dirty="0" err="1"/>
                <a:t>showing</a:t>
              </a:r>
              <a:r>
                <a:rPr lang="nb-NO" sz="1000" dirty="0"/>
                <a:t> abscess (*) in right frontal </a:t>
              </a:r>
              <a:r>
                <a:rPr lang="nb-NO" sz="1000" dirty="0" err="1"/>
                <a:t>lobe</a:t>
              </a:r>
              <a:r>
                <a:rPr lang="nb-NO" sz="1000" dirty="0"/>
                <a:t> </a:t>
              </a:r>
              <a:r>
                <a:rPr lang="nb-NO" sz="1000" dirty="0" err="1"/>
                <a:t>with</a:t>
              </a:r>
              <a:r>
                <a:rPr lang="nb-NO" sz="1000" dirty="0"/>
                <a:t> </a:t>
              </a:r>
              <a:r>
                <a:rPr lang="nb-NO" sz="1000" dirty="0" err="1"/>
                <a:t>peri</a:t>
              </a:r>
              <a:r>
                <a:rPr lang="nb-NO" sz="1000" dirty="0"/>
                <a:t>-abscess </a:t>
              </a:r>
              <a:r>
                <a:rPr lang="nb-NO" sz="1000" dirty="0" err="1"/>
                <a:t>edema</a:t>
              </a:r>
              <a:r>
                <a:rPr lang="nb-NO" sz="1000" dirty="0"/>
                <a:t> (</a:t>
              </a:r>
              <a:r>
                <a:rPr lang="nb-NO" sz="1000" dirty="0" err="1"/>
                <a:t>arrows</a:t>
              </a:r>
              <a:r>
                <a:rPr lang="nb-NO" sz="1000" dirty="0"/>
                <a:t>). b: T2 </a:t>
              </a:r>
              <a:r>
                <a:rPr lang="nb-NO" sz="1000" dirty="0" err="1"/>
                <a:t>weighetd</a:t>
              </a:r>
              <a:r>
                <a:rPr lang="nb-NO" sz="1000" dirty="0"/>
                <a:t> MRI </a:t>
              </a:r>
              <a:r>
                <a:rPr lang="nb-NO" sz="1000" dirty="0" err="1"/>
                <a:t>with</a:t>
              </a:r>
              <a:r>
                <a:rPr lang="nb-NO" sz="1000" dirty="0"/>
                <a:t> FLAIR 1 </a:t>
              </a:r>
              <a:r>
                <a:rPr lang="nb-NO" sz="1000" dirty="0" err="1"/>
                <a:t>year</a:t>
              </a:r>
              <a:r>
                <a:rPr lang="nb-NO" sz="1000" dirty="0"/>
                <a:t> later, </a:t>
              </a:r>
              <a:r>
                <a:rPr lang="nb-NO" sz="1000" dirty="0" err="1"/>
                <a:t>showing</a:t>
              </a:r>
              <a:r>
                <a:rPr lang="nb-NO" sz="1000" dirty="0"/>
                <a:t> </a:t>
              </a:r>
              <a:r>
                <a:rPr lang="nb-NO" sz="1000" dirty="0" err="1"/>
                <a:t>resolution</a:t>
              </a:r>
              <a:r>
                <a:rPr lang="nb-NO" sz="1000" dirty="0"/>
                <a:t> </a:t>
              </a:r>
              <a:r>
                <a:rPr lang="nb-NO" sz="1000" dirty="0" err="1"/>
                <a:t>of</a:t>
              </a:r>
              <a:r>
                <a:rPr lang="nb-NO" sz="1000" dirty="0"/>
                <a:t> </a:t>
              </a:r>
              <a:r>
                <a:rPr lang="nb-NO" sz="1000" dirty="0" err="1"/>
                <a:t>edema</a:t>
              </a:r>
              <a:r>
                <a:rPr lang="nb-NO" sz="1000" dirty="0"/>
                <a:t>. c: FDG-PET/CT 42 </a:t>
              </a:r>
              <a:r>
                <a:rPr lang="nb-NO" sz="1000" dirty="0" err="1"/>
                <a:t>months</a:t>
              </a:r>
              <a:r>
                <a:rPr lang="nb-NO" sz="1000" dirty="0"/>
                <a:t> </a:t>
              </a:r>
              <a:r>
                <a:rPr lang="nb-NO" sz="1000" dirty="0" err="1"/>
                <a:t>after</a:t>
              </a:r>
              <a:r>
                <a:rPr lang="nb-NO" sz="1000" dirty="0"/>
                <a:t> abscess </a:t>
              </a:r>
              <a:r>
                <a:rPr lang="nb-NO" sz="1000" dirty="0" err="1"/>
                <a:t>showing</a:t>
              </a:r>
              <a:r>
                <a:rPr lang="nb-NO" sz="1000" dirty="0"/>
                <a:t> </a:t>
              </a:r>
              <a:r>
                <a:rPr lang="nb-NO" sz="1000" dirty="0" err="1"/>
                <a:t>hypometabolism</a:t>
              </a:r>
              <a:r>
                <a:rPr lang="nb-NO" sz="1000" dirty="0"/>
                <a:t> </a:t>
              </a:r>
              <a:r>
                <a:rPr lang="nb-NO" sz="1000" dirty="0" err="1"/>
                <a:t>coinciding</a:t>
              </a:r>
              <a:r>
                <a:rPr lang="nb-NO" sz="1000" dirty="0"/>
                <a:t> </a:t>
              </a:r>
              <a:r>
                <a:rPr lang="nb-NO" sz="1000" dirty="0" err="1"/>
                <a:t>with</a:t>
              </a:r>
              <a:r>
                <a:rPr lang="nb-NO" sz="1000" dirty="0"/>
                <a:t> </a:t>
              </a:r>
              <a:r>
                <a:rPr lang="nb-NO" sz="1000" dirty="0" err="1"/>
                <a:t>the</a:t>
              </a:r>
              <a:r>
                <a:rPr lang="nb-NO" sz="1000" dirty="0"/>
                <a:t> </a:t>
              </a:r>
              <a:r>
                <a:rPr lang="nb-NO" sz="1000" dirty="0" err="1"/>
                <a:t>edema</a:t>
              </a:r>
              <a:r>
                <a:rPr lang="nb-NO" sz="1000" dirty="0"/>
                <a:t> in </a:t>
              </a:r>
              <a:r>
                <a:rPr lang="nb-NO" sz="1000" dirty="0" err="1"/>
                <a:t>the</a:t>
              </a:r>
              <a:r>
                <a:rPr lang="nb-NO" sz="1000" dirty="0"/>
                <a:t> </a:t>
              </a:r>
              <a:r>
                <a:rPr lang="nb-NO" sz="1000" dirty="0" err="1"/>
                <a:t>acute</a:t>
              </a:r>
              <a:r>
                <a:rPr lang="nb-NO" sz="1000" dirty="0"/>
                <a:t> </a:t>
              </a:r>
              <a:r>
                <a:rPr lang="nb-NO" sz="1000" dirty="0" err="1"/>
                <a:t>phase</a:t>
              </a:r>
              <a:r>
                <a:rPr lang="nb-NO" sz="1000" dirty="0"/>
                <a:t> </a:t>
              </a:r>
              <a:r>
                <a:rPr lang="nb-NO" sz="1000" dirty="0" err="1"/>
                <a:t>of</a:t>
              </a:r>
              <a:r>
                <a:rPr lang="nb-NO" sz="1000" dirty="0"/>
                <a:t> </a:t>
              </a:r>
              <a:r>
                <a:rPr lang="nb-NO" sz="1000" dirty="0" err="1"/>
                <a:t>brain</a:t>
              </a:r>
              <a:r>
                <a:rPr lang="nb-NO" sz="1000" dirty="0"/>
                <a:t> abscess.</a:t>
              </a:r>
            </a:p>
          </p:txBody>
        </p:sp>
        <p:grpSp>
          <p:nvGrpSpPr>
            <p:cNvPr id="40" name="Gruppe 39"/>
            <p:cNvGrpSpPr/>
            <p:nvPr/>
          </p:nvGrpSpPr>
          <p:grpSpPr>
            <a:xfrm>
              <a:off x="142324" y="503832"/>
              <a:ext cx="4903095" cy="2072444"/>
              <a:chOff x="142324" y="503832"/>
              <a:chExt cx="4903095" cy="2072444"/>
            </a:xfrm>
          </p:grpSpPr>
          <p:grpSp>
            <p:nvGrpSpPr>
              <p:cNvPr id="39" name="Gruppe 38"/>
              <p:cNvGrpSpPr/>
              <p:nvPr/>
            </p:nvGrpSpPr>
            <p:grpSpPr>
              <a:xfrm>
                <a:off x="142324" y="503832"/>
                <a:ext cx="2193559" cy="2072443"/>
                <a:chOff x="142324" y="503832"/>
                <a:chExt cx="2193559" cy="2072443"/>
              </a:xfrm>
            </p:grpSpPr>
            <p:pic>
              <p:nvPicPr>
                <p:cNvPr id="30" name="Bilde 29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2324" y="503832"/>
                  <a:ext cx="2193559" cy="2072443"/>
                </a:xfrm>
                <a:prstGeom prst="rect">
                  <a:avLst/>
                </a:prstGeom>
              </p:spPr>
            </p:pic>
            <p:sp>
              <p:nvSpPr>
                <p:cNvPr id="34" name="TekstSylinder 33"/>
                <p:cNvSpPr txBox="1"/>
                <p:nvPr/>
              </p:nvSpPr>
              <p:spPr>
                <a:xfrm>
                  <a:off x="143824" y="519717"/>
                  <a:ext cx="233147" cy="2916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a</a:t>
                  </a:r>
                </a:p>
              </p:txBody>
            </p:sp>
          </p:grpSp>
          <p:grpSp>
            <p:nvGrpSpPr>
              <p:cNvPr id="38" name="Gruppe 37"/>
              <p:cNvGrpSpPr/>
              <p:nvPr/>
            </p:nvGrpSpPr>
            <p:grpSpPr>
              <a:xfrm>
                <a:off x="2349225" y="503833"/>
                <a:ext cx="2364874" cy="2072443"/>
                <a:chOff x="2349225" y="503833"/>
                <a:chExt cx="2364874" cy="2072443"/>
              </a:xfrm>
            </p:grpSpPr>
            <p:pic>
              <p:nvPicPr>
                <p:cNvPr id="33" name="Bilde 3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349225" y="503833"/>
                  <a:ext cx="2364874" cy="2072443"/>
                </a:xfrm>
                <a:prstGeom prst="rect">
                  <a:avLst/>
                </a:prstGeom>
              </p:spPr>
            </p:pic>
            <p:sp>
              <p:nvSpPr>
                <p:cNvPr id="35" name="TekstSylinder 34"/>
                <p:cNvSpPr txBox="1"/>
                <p:nvPr/>
              </p:nvSpPr>
              <p:spPr>
                <a:xfrm>
                  <a:off x="2358074" y="521130"/>
                  <a:ext cx="242006" cy="29162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dirty="0">
                      <a:solidFill>
                        <a:schemeClr val="bg1"/>
                      </a:solidFill>
                    </a:rPr>
                    <a:t>b</a:t>
                  </a:r>
                </a:p>
              </p:txBody>
            </p:sp>
          </p:grpSp>
          <p:sp>
            <p:nvSpPr>
              <p:cNvPr id="36" name="TekstSylinder 35"/>
              <p:cNvSpPr txBox="1"/>
              <p:nvPr/>
            </p:nvSpPr>
            <p:spPr>
              <a:xfrm>
                <a:off x="4762969" y="521130"/>
                <a:ext cx="2824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</p:grpSp>
      </p:grpSp>
      <p:sp>
        <p:nvSpPr>
          <p:cNvPr id="53" name="TekstSylinder 52"/>
          <p:cNvSpPr txBox="1"/>
          <p:nvPr/>
        </p:nvSpPr>
        <p:spPr>
          <a:xfrm>
            <a:off x="738128" y="63392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*</a:t>
            </a:r>
          </a:p>
        </p:txBody>
      </p:sp>
      <p:grpSp>
        <p:nvGrpSpPr>
          <p:cNvPr id="61" name="Gruppe 60"/>
          <p:cNvGrpSpPr/>
          <p:nvPr/>
        </p:nvGrpSpPr>
        <p:grpSpPr>
          <a:xfrm>
            <a:off x="247334" y="3023632"/>
            <a:ext cx="6667787" cy="3226404"/>
            <a:chOff x="247334" y="3563458"/>
            <a:chExt cx="6667787" cy="3226404"/>
          </a:xfrm>
        </p:grpSpPr>
        <p:grpSp>
          <p:nvGrpSpPr>
            <p:cNvPr id="52" name="Gruppe 51"/>
            <p:cNvGrpSpPr/>
            <p:nvPr/>
          </p:nvGrpSpPr>
          <p:grpSpPr>
            <a:xfrm>
              <a:off x="247334" y="3563458"/>
              <a:ext cx="6667787" cy="3226404"/>
              <a:chOff x="247334" y="3563458"/>
              <a:chExt cx="6667787" cy="3226404"/>
            </a:xfrm>
          </p:grpSpPr>
          <p:grpSp>
            <p:nvGrpSpPr>
              <p:cNvPr id="47" name="Gruppe 46"/>
              <p:cNvGrpSpPr/>
              <p:nvPr/>
            </p:nvGrpSpPr>
            <p:grpSpPr>
              <a:xfrm>
                <a:off x="247334" y="3564624"/>
                <a:ext cx="6667787" cy="3225238"/>
                <a:chOff x="247334" y="3443437"/>
                <a:chExt cx="6667787" cy="3225238"/>
              </a:xfrm>
            </p:grpSpPr>
            <p:grpSp>
              <p:nvGrpSpPr>
                <p:cNvPr id="45" name="Gruppe 44"/>
                <p:cNvGrpSpPr>
                  <a:grpSpLocks noChangeAspect="1"/>
                </p:cNvGrpSpPr>
                <p:nvPr/>
              </p:nvGrpSpPr>
              <p:grpSpPr>
                <a:xfrm>
                  <a:off x="519545" y="3443437"/>
                  <a:ext cx="5975793" cy="2692956"/>
                  <a:chOff x="1297389" y="4472848"/>
                  <a:chExt cx="3733784" cy="1682608"/>
                </a:xfrm>
              </p:grpSpPr>
              <p:pic>
                <p:nvPicPr>
                  <p:cNvPr id="43" name="Bilde 42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1297389" y="4472848"/>
                    <a:ext cx="1816073" cy="1682608"/>
                  </a:xfrm>
                  <a:prstGeom prst="rect">
                    <a:avLst/>
                  </a:prstGeom>
                </p:spPr>
              </p:pic>
              <p:pic>
                <p:nvPicPr>
                  <p:cNvPr id="44" name="Bilde 43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3156267" y="4472848"/>
                    <a:ext cx="1874906" cy="1682608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46" name="TekstSylinder 45"/>
                <p:cNvSpPr txBox="1"/>
                <p:nvPr/>
              </p:nvSpPr>
              <p:spPr>
                <a:xfrm>
                  <a:off x="247334" y="6114677"/>
                  <a:ext cx="6667787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b-NO" sz="1000" dirty="0"/>
                    <a:t>a: T2-weighted FLAIR MRI </a:t>
                  </a:r>
                  <a:r>
                    <a:rPr lang="nb-NO" sz="1000" dirty="0" err="1"/>
                    <a:t>showing</a:t>
                  </a:r>
                  <a:r>
                    <a:rPr lang="nb-NO" sz="1000" dirty="0"/>
                    <a:t> abscess (*) in right frontal </a:t>
                  </a:r>
                  <a:r>
                    <a:rPr lang="nb-NO" sz="1000" dirty="0" err="1"/>
                    <a:t>lob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with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peri</a:t>
                  </a:r>
                  <a:r>
                    <a:rPr lang="nb-NO" sz="1000" dirty="0"/>
                    <a:t>-abscess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(</a:t>
                  </a:r>
                  <a:r>
                    <a:rPr lang="nb-NO" sz="1000" dirty="0" err="1"/>
                    <a:t>arrows</a:t>
                  </a:r>
                  <a:r>
                    <a:rPr lang="nb-NO" sz="1000" dirty="0"/>
                    <a:t>). b: FDG-PET/CT 93 </a:t>
                  </a:r>
                  <a:r>
                    <a:rPr lang="nb-NO" sz="1000" dirty="0" err="1"/>
                    <a:t>months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after</a:t>
                  </a:r>
                  <a:r>
                    <a:rPr lang="nb-NO" sz="1000" dirty="0"/>
                    <a:t> abscess </a:t>
                  </a:r>
                  <a:r>
                    <a:rPr lang="nb-NO" sz="1000" dirty="0" err="1"/>
                    <a:t>show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hypometabolism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coinciding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with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in </a:t>
                  </a:r>
                  <a:r>
                    <a:rPr lang="nb-NO" sz="1000" dirty="0" err="1"/>
                    <a:t>th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acut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phase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of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brain</a:t>
                  </a:r>
                  <a:r>
                    <a:rPr lang="nb-NO" sz="1000" dirty="0"/>
                    <a:t> abscess (</a:t>
                  </a:r>
                  <a:r>
                    <a:rPr lang="nb-NO" sz="1000" dirty="0" err="1"/>
                    <a:t>arrows</a:t>
                  </a:r>
                  <a:r>
                    <a:rPr lang="nb-NO" sz="1000" dirty="0"/>
                    <a:t>). </a:t>
                  </a:r>
                  <a:r>
                    <a:rPr lang="nb-NO" sz="1000" dirty="0" err="1"/>
                    <a:t>Axial</a:t>
                  </a:r>
                  <a:r>
                    <a:rPr lang="nb-NO" sz="1000" dirty="0"/>
                    <a:t> CT </a:t>
                  </a:r>
                  <a:r>
                    <a:rPr lang="nb-NO" sz="1000" dirty="0" err="1"/>
                    <a:t>showed</a:t>
                  </a:r>
                  <a:r>
                    <a:rPr lang="nb-NO" sz="1000" dirty="0"/>
                    <a:t> absence </a:t>
                  </a:r>
                  <a:r>
                    <a:rPr lang="nb-NO" sz="1000" dirty="0" err="1"/>
                    <a:t>of</a:t>
                  </a:r>
                  <a:r>
                    <a:rPr lang="nb-NO" sz="1000" dirty="0"/>
                    <a:t> </a:t>
                  </a:r>
                  <a:r>
                    <a:rPr lang="nb-NO" sz="1000" dirty="0" err="1"/>
                    <a:t>edema</a:t>
                  </a:r>
                  <a:r>
                    <a:rPr lang="nb-NO" sz="1000" dirty="0"/>
                    <a:t> (not </a:t>
                  </a:r>
                  <a:r>
                    <a:rPr lang="nb-NO" sz="1000" dirty="0" err="1"/>
                    <a:t>shown</a:t>
                  </a:r>
                  <a:r>
                    <a:rPr lang="nb-NO" sz="1000" dirty="0"/>
                    <a:t>); </a:t>
                  </a:r>
                  <a:r>
                    <a:rPr lang="nb-NO" sz="1000" dirty="0" err="1"/>
                    <a:t>coronal</a:t>
                  </a:r>
                  <a:r>
                    <a:rPr lang="nb-NO" sz="1000" dirty="0"/>
                    <a:t> CT </a:t>
                  </a:r>
                  <a:r>
                    <a:rPr lang="nb-NO" sz="1000" dirty="0" err="1"/>
                    <a:t>was</a:t>
                  </a:r>
                  <a:r>
                    <a:rPr lang="nb-NO" sz="1000" dirty="0"/>
                    <a:t> not </a:t>
                  </a:r>
                  <a:r>
                    <a:rPr lang="nb-NO" sz="1000" dirty="0" err="1"/>
                    <a:t>obtained</a:t>
                  </a:r>
                  <a:r>
                    <a:rPr lang="nb-NO" sz="1000" dirty="0"/>
                    <a:t>.</a:t>
                  </a:r>
                </a:p>
              </p:txBody>
            </p:sp>
          </p:grpSp>
          <p:sp>
            <p:nvSpPr>
              <p:cNvPr id="48" name="TekstSylinder 47"/>
              <p:cNvSpPr txBox="1"/>
              <p:nvPr/>
            </p:nvSpPr>
            <p:spPr>
              <a:xfrm>
                <a:off x="521175" y="3563458"/>
                <a:ext cx="255793" cy="326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dirty="0">
                    <a:solidFill>
                      <a:schemeClr val="bg1"/>
                    </a:solidFill>
                  </a:rPr>
                  <a:t>a</a:t>
                </a:r>
              </a:p>
            </p:txBody>
          </p:sp>
          <p:sp>
            <p:nvSpPr>
              <p:cNvPr id="49" name="TekstSylinder 48"/>
              <p:cNvSpPr txBox="1"/>
              <p:nvPr/>
            </p:nvSpPr>
            <p:spPr>
              <a:xfrm>
                <a:off x="3496649" y="3565037"/>
                <a:ext cx="265513" cy="3263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dirty="0">
                    <a:solidFill>
                      <a:schemeClr val="bg1"/>
                    </a:solidFill>
                  </a:rPr>
                  <a:t>b</a:t>
                </a:r>
              </a:p>
            </p:txBody>
          </p:sp>
        </p:grpSp>
        <p:sp>
          <p:nvSpPr>
            <p:cNvPr id="54" name="TekstSylinder 53"/>
            <p:cNvSpPr txBox="1"/>
            <p:nvPr/>
          </p:nvSpPr>
          <p:spPr>
            <a:xfrm>
              <a:off x="1573572" y="434982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*</a:t>
              </a:r>
            </a:p>
          </p:txBody>
        </p:sp>
        <p:cxnSp>
          <p:nvCxnSpPr>
            <p:cNvPr id="56" name="Rett pilkobling 55"/>
            <p:cNvCxnSpPr/>
            <p:nvPr/>
          </p:nvCxnSpPr>
          <p:spPr>
            <a:xfrm>
              <a:off x="888169" y="4175393"/>
              <a:ext cx="150041" cy="174434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Rett pilkobling 56"/>
            <p:cNvCxnSpPr/>
            <p:nvPr/>
          </p:nvCxnSpPr>
          <p:spPr>
            <a:xfrm flipH="1">
              <a:off x="1895693" y="3880851"/>
              <a:ext cx="136395" cy="202737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Rett pilkobling 58"/>
            <p:cNvCxnSpPr/>
            <p:nvPr/>
          </p:nvCxnSpPr>
          <p:spPr>
            <a:xfrm>
              <a:off x="3882925" y="3964232"/>
              <a:ext cx="150041" cy="174434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Rett pilkobling 59"/>
            <p:cNvCxnSpPr/>
            <p:nvPr/>
          </p:nvCxnSpPr>
          <p:spPr>
            <a:xfrm flipH="1">
              <a:off x="4890449" y="3669690"/>
              <a:ext cx="136395" cy="202737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kstSylinder 67"/>
          <p:cNvSpPr txBox="1"/>
          <p:nvPr/>
        </p:nvSpPr>
        <p:spPr>
          <a:xfrm>
            <a:off x="339424" y="9025926"/>
            <a:ext cx="666778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a: T2-weighted FLAIR MRI </a:t>
            </a:r>
            <a:r>
              <a:rPr lang="nb-NO" sz="1000" dirty="0" err="1"/>
              <a:t>showing</a:t>
            </a:r>
            <a:r>
              <a:rPr lang="nb-NO" sz="1000" dirty="0"/>
              <a:t> abscess (*) in right frontal </a:t>
            </a:r>
            <a:r>
              <a:rPr lang="nb-NO" sz="1000" dirty="0" err="1"/>
              <a:t>lobe</a:t>
            </a:r>
            <a:r>
              <a:rPr lang="nb-NO" sz="1000" dirty="0"/>
              <a:t> </a:t>
            </a:r>
            <a:r>
              <a:rPr lang="nb-NO" sz="1000" dirty="0" err="1"/>
              <a:t>with</a:t>
            </a:r>
            <a:r>
              <a:rPr lang="nb-NO" sz="1000" dirty="0"/>
              <a:t> </a:t>
            </a:r>
            <a:r>
              <a:rPr lang="nb-NO" sz="1000" dirty="0" err="1"/>
              <a:t>peri</a:t>
            </a:r>
            <a:r>
              <a:rPr lang="nb-NO" sz="1000" dirty="0"/>
              <a:t>-abscess </a:t>
            </a:r>
            <a:r>
              <a:rPr lang="nb-NO" sz="1000" dirty="0" err="1"/>
              <a:t>edema</a:t>
            </a:r>
            <a:r>
              <a:rPr lang="nb-NO" sz="1000" dirty="0"/>
              <a:t> (</a:t>
            </a:r>
            <a:r>
              <a:rPr lang="nb-NO" sz="1000" dirty="0" err="1"/>
              <a:t>arrows</a:t>
            </a:r>
            <a:r>
              <a:rPr lang="nb-NO" sz="1000" dirty="0"/>
              <a:t>). b: FDG-PET/CT 93 </a:t>
            </a:r>
            <a:r>
              <a:rPr lang="nb-NO" sz="1000" dirty="0" err="1"/>
              <a:t>months</a:t>
            </a:r>
            <a:r>
              <a:rPr lang="nb-NO" sz="1000" dirty="0"/>
              <a:t> </a:t>
            </a:r>
            <a:r>
              <a:rPr lang="nb-NO" sz="1000" dirty="0" err="1"/>
              <a:t>after</a:t>
            </a:r>
            <a:r>
              <a:rPr lang="nb-NO" sz="1000" dirty="0"/>
              <a:t> abscess </a:t>
            </a:r>
            <a:r>
              <a:rPr lang="nb-NO" sz="1000" dirty="0" err="1"/>
              <a:t>showing</a:t>
            </a:r>
            <a:r>
              <a:rPr lang="nb-NO" sz="1000" dirty="0"/>
              <a:t> </a:t>
            </a:r>
            <a:r>
              <a:rPr lang="nb-NO" sz="1000" dirty="0" err="1"/>
              <a:t>hypometabolism</a:t>
            </a:r>
            <a:r>
              <a:rPr lang="nb-NO" sz="1000" dirty="0"/>
              <a:t> </a:t>
            </a:r>
            <a:r>
              <a:rPr lang="nb-NO" sz="1000" dirty="0" err="1"/>
              <a:t>coinciding</a:t>
            </a:r>
            <a:r>
              <a:rPr lang="nb-NO" sz="1000" dirty="0"/>
              <a:t> </a:t>
            </a:r>
            <a:r>
              <a:rPr lang="nb-NO" sz="1000" dirty="0" err="1"/>
              <a:t>with</a:t>
            </a:r>
            <a:r>
              <a:rPr lang="nb-NO" sz="1000" dirty="0"/>
              <a:t> </a:t>
            </a:r>
            <a:r>
              <a:rPr lang="nb-NO" sz="1000" dirty="0" err="1"/>
              <a:t>the</a:t>
            </a:r>
            <a:r>
              <a:rPr lang="nb-NO" sz="1000" dirty="0"/>
              <a:t> </a:t>
            </a:r>
            <a:r>
              <a:rPr lang="nb-NO" sz="1000" dirty="0" err="1"/>
              <a:t>edema</a:t>
            </a:r>
            <a:r>
              <a:rPr lang="nb-NO" sz="1000" dirty="0"/>
              <a:t> in </a:t>
            </a:r>
            <a:r>
              <a:rPr lang="nb-NO" sz="1000" dirty="0" err="1"/>
              <a:t>the</a:t>
            </a:r>
            <a:r>
              <a:rPr lang="nb-NO" sz="1000" dirty="0"/>
              <a:t> </a:t>
            </a:r>
            <a:r>
              <a:rPr lang="nb-NO" sz="1000" dirty="0" err="1"/>
              <a:t>acute</a:t>
            </a:r>
            <a:r>
              <a:rPr lang="nb-NO" sz="1000" dirty="0"/>
              <a:t> </a:t>
            </a:r>
            <a:r>
              <a:rPr lang="nb-NO" sz="1000" dirty="0" err="1"/>
              <a:t>phase</a:t>
            </a:r>
            <a:r>
              <a:rPr lang="nb-NO" sz="1000" dirty="0"/>
              <a:t> </a:t>
            </a:r>
            <a:r>
              <a:rPr lang="nb-NO" sz="1000" dirty="0" err="1"/>
              <a:t>of</a:t>
            </a:r>
            <a:r>
              <a:rPr lang="nb-NO" sz="1000" dirty="0"/>
              <a:t> </a:t>
            </a:r>
            <a:r>
              <a:rPr lang="nb-NO" sz="1000" dirty="0" err="1"/>
              <a:t>brain</a:t>
            </a:r>
            <a:r>
              <a:rPr lang="nb-NO" sz="1000" dirty="0"/>
              <a:t> abscess (</a:t>
            </a:r>
            <a:r>
              <a:rPr lang="nb-NO" sz="1000" dirty="0" err="1"/>
              <a:t>arrows</a:t>
            </a:r>
            <a:r>
              <a:rPr lang="nb-NO" sz="1000" dirty="0"/>
              <a:t>). </a:t>
            </a:r>
            <a:r>
              <a:rPr lang="nb-NO" sz="1000" dirty="0" err="1"/>
              <a:t>Axial</a:t>
            </a:r>
            <a:r>
              <a:rPr lang="nb-NO" sz="1000" dirty="0"/>
              <a:t> CT </a:t>
            </a:r>
            <a:r>
              <a:rPr lang="nb-NO" sz="1000" dirty="0" err="1"/>
              <a:t>showed</a:t>
            </a:r>
            <a:r>
              <a:rPr lang="nb-NO" sz="1000" dirty="0"/>
              <a:t> absence </a:t>
            </a:r>
            <a:r>
              <a:rPr lang="nb-NO" sz="1000" dirty="0" err="1"/>
              <a:t>of</a:t>
            </a:r>
            <a:r>
              <a:rPr lang="nb-NO" sz="1000" dirty="0"/>
              <a:t> </a:t>
            </a:r>
            <a:r>
              <a:rPr lang="nb-NO" sz="1000" dirty="0" err="1"/>
              <a:t>edema</a:t>
            </a:r>
            <a:r>
              <a:rPr lang="nb-NO" sz="1000" dirty="0"/>
              <a:t> (not </a:t>
            </a:r>
            <a:r>
              <a:rPr lang="nb-NO" sz="1000" dirty="0" err="1"/>
              <a:t>shown</a:t>
            </a:r>
            <a:r>
              <a:rPr lang="nb-NO" sz="1000" dirty="0"/>
              <a:t>); </a:t>
            </a:r>
            <a:r>
              <a:rPr lang="nb-NO" sz="1000" dirty="0" err="1"/>
              <a:t>coronal</a:t>
            </a:r>
            <a:r>
              <a:rPr lang="nb-NO" sz="1000" dirty="0"/>
              <a:t> CT </a:t>
            </a:r>
            <a:r>
              <a:rPr lang="nb-NO" sz="1000" dirty="0" err="1"/>
              <a:t>was</a:t>
            </a:r>
            <a:r>
              <a:rPr lang="nb-NO" sz="1000" dirty="0"/>
              <a:t> not </a:t>
            </a:r>
            <a:r>
              <a:rPr lang="nb-NO" sz="1000" dirty="0" err="1"/>
              <a:t>obtained</a:t>
            </a:r>
            <a:r>
              <a:rPr lang="nb-NO" sz="1000" dirty="0"/>
              <a:t>.</a:t>
            </a:r>
          </a:p>
        </p:txBody>
      </p:sp>
      <p:cxnSp>
        <p:nvCxnSpPr>
          <p:cNvPr id="70" name="Rett pilkobling 69"/>
          <p:cNvCxnSpPr/>
          <p:nvPr/>
        </p:nvCxnSpPr>
        <p:spPr>
          <a:xfrm>
            <a:off x="207286" y="818868"/>
            <a:ext cx="150041" cy="17443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Rett pilkobling 70"/>
          <p:cNvCxnSpPr/>
          <p:nvPr/>
        </p:nvCxnSpPr>
        <p:spPr>
          <a:xfrm flipH="1">
            <a:off x="1150262" y="459778"/>
            <a:ext cx="136395" cy="20273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7" name="Gruppe 76"/>
          <p:cNvGrpSpPr/>
          <p:nvPr/>
        </p:nvGrpSpPr>
        <p:grpSpPr>
          <a:xfrm>
            <a:off x="386686" y="6353582"/>
            <a:ext cx="6390632" cy="2716406"/>
            <a:chOff x="386686" y="6353582"/>
            <a:chExt cx="6390632" cy="2716406"/>
          </a:xfrm>
        </p:grpSpPr>
        <p:grpSp>
          <p:nvGrpSpPr>
            <p:cNvPr id="65" name="Gruppe 64"/>
            <p:cNvGrpSpPr>
              <a:grpSpLocks noChangeAspect="1"/>
            </p:cNvGrpSpPr>
            <p:nvPr/>
          </p:nvGrpSpPr>
          <p:grpSpPr>
            <a:xfrm>
              <a:off x="386686" y="6353582"/>
              <a:ext cx="6390632" cy="2716406"/>
              <a:chOff x="182290" y="6438334"/>
              <a:chExt cx="6773342" cy="2879081"/>
            </a:xfrm>
          </p:grpSpPr>
          <p:pic>
            <p:nvPicPr>
              <p:cNvPr id="62" name="Bilde 61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843195" y="6438334"/>
                <a:ext cx="2112437" cy="2879081"/>
              </a:xfrm>
              <a:prstGeom prst="rect">
                <a:avLst/>
              </a:prstGeom>
            </p:spPr>
          </p:pic>
          <p:pic>
            <p:nvPicPr>
              <p:cNvPr id="63" name="Bilde 6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519445" y="6438334"/>
                <a:ext cx="2292602" cy="2879081"/>
              </a:xfrm>
              <a:prstGeom prst="rect">
                <a:avLst/>
              </a:prstGeom>
            </p:spPr>
          </p:pic>
          <p:pic>
            <p:nvPicPr>
              <p:cNvPr id="64" name="Bilde 6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82290" y="6438334"/>
                <a:ext cx="2311375" cy="2879081"/>
              </a:xfrm>
              <a:prstGeom prst="rect">
                <a:avLst/>
              </a:prstGeom>
            </p:spPr>
          </p:pic>
        </p:grpSp>
        <p:sp>
          <p:nvSpPr>
            <p:cNvPr id="69" name="TekstSylinder 68"/>
            <p:cNvSpPr txBox="1"/>
            <p:nvPr/>
          </p:nvSpPr>
          <p:spPr>
            <a:xfrm>
              <a:off x="663107" y="798157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>
                  <a:solidFill>
                    <a:schemeClr val="bg1"/>
                  </a:solidFill>
                </a:rPr>
                <a:t>*</a:t>
              </a:r>
            </a:p>
          </p:txBody>
        </p:sp>
        <p:cxnSp>
          <p:nvCxnSpPr>
            <p:cNvPr id="72" name="Rett pilkobling 71"/>
            <p:cNvCxnSpPr/>
            <p:nvPr/>
          </p:nvCxnSpPr>
          <p:spPr>
            <a:xfrm>
              <a:off x="502686" y="7725262"/>
              <a:ext cx="150041" cy="174434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Rett pilkobling 72"/>
            <p:cNvCxnSpPr/>
            <p:nvPr/>
          </p:nvCxnSpPr>
          <p:spPr>
            <a:xfrm flipV="1">
              <a:off x="590687" y="8299525"/>
              <a:ext cx="171408" cy="206476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Rett pilkobling 74"/>
            <p:cNvCxnSpPr/>
            <p:nvPr/>
          </p:nvCxnSpPr>
          <p:spPr>
            <a:xfrm>
              <a:off x="2763592" y="7684018"/>
              <a:ext cx="150041" cy="174434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Rett pilkobling 75"/>
            <p:cNvCxnSpPr/>
            <p:nvPr/>
          </p:nvCxnSpPr>
          <p:spPr>
            <a:xfrm flipV="1">
              <a:off x="2851593" y="8258281"/>
              <a:ext cx="171408" cy="206476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Bilde 2">
            <a:extLst>
              <a:ext uri="{FF2B5EF4-FFF2-40B4-BE49-F238E27FC236}">
                <a16:creationId xmlns:a16="http://schemas.microsoft.com/office/drawing/2014/main" id="{CF31464E-FB30-57A9-A25A-D3E23C04740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16415" y="272475"/>
            <a:ext cx="2432460" cy="2072443"/>
          </a:xfrm>
          <a:prstGeom prst="rect">
            <a:avLst/>
          </a:prstGeom>
        </p:spPr>
      </p:pic>
      <p:cxnSp>
        <p:nvCxnSpPr>
          <p:cNvPr id="3" name="Rett pilkobling 69">
            <a:extLst>
              <a:ext uri="{FF2B5EF4-FFF2-40B4-BE49-F238E27FC236}">
                <a16:creationId xmlns:a16="http://schemas.microsoft.com/office/drawing/2014/main" id="{6B0D3939-B047-C5B5-6B60-B5CE7298A571}"/>
              </a:ext>
            </a:extLst>
          </p:cNvPr>
          <p:cNvCxnSpPr/>
          <p:nvPr/>
        </p:nvCxnSpPr>
        <p:spPr>
          <a:xfrm>
            <a:off x="5101471" y="553280"/>
            <a:ext cx="150041" cy="17443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Rett pilkobling 70">
            <a:extLst>
              <a:ext uri="{FF2B5EF4-FFF2-40B4-BE49-F238E27FC236}">
                <a16:creationId xmlns:a16="http://schemas.microsoft.com/office/drawing/2014/main" id="{8C26DCFB-81E8-FFFD-4EC8-CF6241116794}"/>
              </a:ext>
            </a:extLst>
          </p:cNvPr>
          <p:cNvCxnSpPr/>
          <p:nvPr/>
        </p:nvCxnSpPr>
        <p:spPr>
          <a:xfrm flipH="1">
            <a:off x="5730958" y="422775"/>
            <a:ext cx="136395" cy="20273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0377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463b6811-b0a4-4b2a-b932-72c4c970c5d2}" enabled="0" method="" siteId="{463b6811-b0a4-4b2a-b932-72c4c970c5d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1</TotalTime>
  <Words>602</Words>
  <Application>Microsoft Office PowerPoint</Application>
  <PresentationFormat>Egendefinert</PresentationFormat>
  <Paragraphs>60</Paragraphs>
  <Slides>4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ema</vt:lpstr>
      <vt:lpstr>PowerPoint-presentasjon</vt:lpstr>
      <vt:lpstr>PowerPoint-presentasjon</vt:lpstr>
      <vt:lpstr>PowerPoint-presentasjon</vt:lpstr>
      <vt:lpstr>PowerPoint-presentasj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jørnar Hassel</dc:creator>
  <cp:lastModifiedBy>Mona-Elisabeth Rootwelt-Revheim</cp:lastModifiedBy>
  <cp:revision>11</cp:revision>
  <dcterms:created xsi:type="dcterms:W3CDTF">2024-05-06T10:20:20Z</dcterms:created>
  <dcterms:modified xsi:type="dcterms:W3CDTF">2024-09-01T14:14:19Z</dcterms:modified>
</cp:coreProperties>
</file>